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  <p:sldId id="258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132"/>
    <p:restoredTop sz="93054"/>
  </p:normalViewPr>
  <p:slideViewPr>
    <p:cSldViewPr snapToGrid="0" snapToObjects="1">
      <p:cViewPr varScale="1">
        <p:scale>
          <a:sx n="82" d="100"/>
          <a:sy n="82" d="100"/>
        </p:scale>
        <p:origin x="358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akira\home\habtamu.tura\New%20folder%20(2)\logger_2016%20edited\Logger_2016%20final.xls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6296682171635438E-2"/>
          <c:y val="3.1568697026887457E-2"/>
          <c:w val="0.76281340783298235"/>
          <c:h val="0.640254705336747"/>
        </c:manualLayout>
      </c:layout>
      <c:lineChart>
        <c:grouping val="standard"/>
        <c:varyColors val="0"/>
        <c:ser>
          <c:idx val="0"/>
          <c:order val="0"/>
          <c:tx>
            <c:strRef>
              <c:f>Sheet3!$B$1</c:f>
              <c:strCache>
                <c:ptCount val="1"/>
                <c:pt idx="0">
                  <c:v>Soil-water-tension(Kpa)_10 cM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numRef>
              <c:f>Sheet3!$A$2:$A$134</c:f>
              <c:numCache>
                <c:formatCode>m/d/yyyy</c:formatCode>
                <c:ptCount val="133"/>
                <c:pt idx="0">
                  <c:v>42592</c:v>
                </c:pt>
                <c:pt idx="1">
                  <c:v>42593</c:v>
                </c:pt>
                <c:pt idx="2">
                  <c:v>42594</c:v>
                </c:pt>
                <c:pt idx="3">
                  <c:v>42595</c:v>
                </c:pt>
                <c:pt idx="4">
                  <c:v>42596</c:v>
                </c:pt>
                <c:pt idx="5">
                  <c:v>42597</c:v>
                </c:pt>
                <c:pt idx="6">
                  <c:v>42598</c:v>
                </c:pt>
                <c:pt idx="7">
                  <c:v>42599</c:v>
                </c:pt>
                <c:pt idx="8">
                  <c:v>42600</c:v>
                </c:pt>
                <c:pt idx="9">
                  <c:v>42601</c:v>
                </c:pt>
                <c:pt idx="10">
                  <c:v>42602</c:v>
                </c:pt>
                <c:pt idx="11">
                  <c:v>42603</c:v>
                </c:pt>
                <c:pt idx="12">
                  <c:v>42604</c:v>
                </c:pt>
                <c:pt idx="13">
                  <c:v>42605</c:v>
                </c:pt>
                <c:pt idx="14">
                  <c:v>42606</c:v>
                </c:pt>
                <c:pt idx="15">
                  <c:v>42607</c:v>
                </c:pt>
                <c:pt idx="16">
                  <c:v>42608</c:v>
                </c:pt>
                <c:pt idx="17">
                  <c:v>42609</c:v>
                </c:pt>
                <c:pt idx="18">
                  <c:v>42610</c:v>
                </c:pt>
                <c:pt idx="19">
                  <c:v>42611</c:v>
                </c:pt>
                <c:pt idx="20">
                  <c:v>42612</c:v>
                </c:pt>
                <c:pt idx="21">
                  <c:v>42613</c:v>
                </c:pt>
                <c:pt idx="22">
                  <c:v>42614</c:v>
                </c:pt>
                <c:pt idx="23">
                  <c:v>42615</c:v>
                </c:pt>
                <c:pt idx="24">
                  <c:v>42616</c:v>
                </c:pt>
                <c:pt idx="25">
                  <c:v>42617</c:v>
                </c:pt>
                <c:pt idx="26">
                  <c:v>42618</c:v>
                </c:pt>
                <c:pt idx="27">
                  <c:v>42619</c:v>
                </c:pt>
                <c:pt idx="28">
                  <c:v>42620</c:v>
                </c:pt>
                <c:pt idx="29">
                  <c:v>42621</c:v>
                </c:pt>
                <c:pt idx="30">
                  <c:v>42622</c:v>
                </c:pt>
                <c:pt idx="31">
                  <c:v>42623</c:v>
                </c:pt>
                <c:pt idx="32">
                  <c:v>42624</c:v>
                </c:pt>
                <c:pt idx="33">
                  <c:v>42625</c:v>
                </c:pt>
                <c:pt idx="34">
                  <c:v>42626</c:v>
                </c:pt>
                <c:pt idx="35">
                  <c:v>42627</c:v>
                </c:pt>
                <c:pt idx="36">
                  <c:v>42628</c:v>
                </c:pt>
                <c:pt idx="37">
                  <c:v>42629</c:v>
                </c:pt>
                <c:pt idx="38">
                  <c:v>42630</c:v>
                </c:pt>
                <c:pt idx="39">
                  <c:v>42631</c:v>
                </c:pt>
                <c:pt idx="40">
                  <c:v>42632</c:v>
                </c:pt>
                <c:pt idx="41">
                  <c:v>42633</c:v>
                </c:pt>
                <c:pt idx="42">
                  <c:v>42634</c:v>
                </c:pt>
                <c:pt idx="43">
                  <c:v>42635</c:v>
                </c:pt>
                <c:pt idx="44">
                  <c:v>42636</c:v>
                </c:pt>
                <c:pt idx="45">
                  <c:v>42637</c:v>
                </c:pt>
                <c:pt idx="46">
                  <c:v>42638</c:v>
                </c:pt>
                <c:pt idx="47">
                  <c:v>42639</c:v>
                </c:pt>
                <c:pt idx="48">
                  <c:v>42640</c:v>
                </c:pt>
                <c:pt idx="49">
                  <c:v>42641</c:v>
                </c:pt>
                <c:pt idx="50">
                  <c:v>42642</c:v>
                </c:pt>
                <c:pt idx="51">
                  <c:v>42643</c:v>
                </c:pt>
                <c:pt idx="52">
                  <c:v>42644</c:v>
                </c:pt>
                <c:pt idx="53">
                  <c:v>42645</c:v>
                </c:pt>
                <c:pt idx="54">
                  <c:v>42646</c:v>
                </c:pt>
                <c:pt idx="55">
                  <c:v>42647</c:v>
                </c:pt>
                <c:pt idx="56">
                  <c:v>42648</c:v>
                </c:pt>
                <c:pt idx="57">
                  <c:v>42649</c:v>
                </c:pt>
                <c:pt idx="58">
                  <c:v>42650</c:v>
                </c:pt>
                <c:pt idx="59">
                  <c:v>42651</c:v>
                </c:pt>
                <c:pt idx="60">
                  <c:v>42652</c:v>
                </c:pt>
                <c:pt idx="61">
                  <c:v>42653</c:v>
                </c:pt>
                <c:pt idx="62">
                  <c:v>42654</c:v>
                </c:pt>
                <c:pt idx="63">
                  <c:v>42655</c:v>
                </c:pt>
                <c:pt idx="64">
                  <c:v>42656</c:v>
                </c:pt>
                <c:pt idx="65">
                  <c:v>42657</c:v>
                </c:pt>
                <c:pt idx="66">
                  <c:v>42658</c:v>
                </c:pt>
                <c:pt idx="67">
                  <c:v>42659</c:v>
                </c:pt>
                <c:pt idx="68">
                  <c:v>42660</c:v>
                </c:pt>
                <c:pt idx="69">
                  <c:v>42661</c:v>
                </c:pt>
                <c:pt idx="70">
                  <c:v>42662</c:v>
                </c:pt>
                <c:pt idx="71">
                  <c:v>42663</c:v>
                </c:pt>
                <c:pt idx="72">
                  <c:v>42664</c:v>
                </c:pt>
                <c:pt idx="73">
                  <c:v>42665</c:v>
                </c:pt>
                <c:pt idx="74">
                  <c:v>42666</c:v>
                </c:pt>
                <c:pt idx="75">
                  <c:v>42667</c:v>
                </c:pt>
                <c:pt idx="76">
                  <c:v>42668</c:v>
                </c:pt>
                <c:pt idx="77">
                  <c:v>42669</c:v>
                </c:pt>
                <c:pt idx="78">
                  <c:v>42670</c:v>
                </c:pt>
                <c:pt idx="79">
                  <c:v>42671</c:v>
                </c:pt>
                <c:pt idx="80">
                  <c:v>42672</c:v>
                </c:pt>
                <c:pt idx="81">
                  <c:v>42673</c:v>
                </c:pt>
                <c:pt idx="82">
                  <c:v>42674</c:v>
                </c:pt>
                <c:pt idx="83">
                  <c:v>42675</c:v>
                </c:pt>
                <c:pt idx="84">
                  <c:v>42676</c:v>
                </c:pt>
                <c:pt idx="85">
                  <c:v>42677</c:v>
                </c:pt>
                <c:pt idx="86">
                  <c:v>42678</c:v>
                </c:pt>
                <c:pt idx="87">
                  <c:v>42679</c:v>
                </c:pt>
                <c:pt idx="88">
                  <c:v>42680</c:v>
                </c:pt>
                <c:pt idx="89">
                  <c:v>42681</c:v>
                </c:pt>
                <c:pt idx="90">
                  <c:v>42682</c:v>
                </c:pt>
                <c:pt idx="91">
                  <c:v>42683</c:v>
                </c:pt>
                <c:pt idx="92">
                  <c:v>42684</c:v>
                </c:pt>
                <c:pt idx="93">
                  <c:v>42685</c:v>
                </c:pt>
                <c:pt idx="94">
                  <c:v>42686</c:v>
                </c:pt>
                <c:pt idx="95">
                  <c:v>42687</c:v>
                </c:pt>
                <c:pt idx="96">
                  <c:v>42688</c:v>
                </c:pt>
                <c:pt idx="97">
                  <c:v>42689</c:v>
                </c:pt>
                <c:pt idx="98">
                  <c:v>42690</c:v>
                </c:pt>
                <c:pt idx="99">
                  <c:v>42691</c:v>
                </c:pt>
                <c:pt idx="100">
                  <c:v>42692</c:v>
                </c:pt>
                <c:pt idx="101">
                  <c:v>42693</c:v>
                </c:pt>
                <c:pt idx="102">
                  <c:v>42694</c:v>
                </c:pt>
                <c:pt idx="103">
                  <c:v>42695</c:v>
                </c:pt>
                <c:pt idx="104">
                  <c:v>42696</c:v>
                </c:pt>
                <c:pt idx="105">
                  <c:v>42697</c:v>
                </c:pt>
                <c:pt idx="106">
                  <c:v>42698</c:v>
                </c:pt>
                <c:pt idx="107">
                  <c:v>42699</c:v>
                </c:pt>
                <c:pt idx="108">
                  <c:v>42700</c:v>
                </c:pt>
                <c:pt idx="109">
                  <c:v>42701</c:v>
                </c:pt>
                <c:pt idx="110">
                  <c:v>42702</c:v>
                </c:pt>
                <c:pt idx="111">
                  <c:v>42703</c:v>
                </c:pt>
                <c:pt idx="112">
                  <c:v>42704</c:v>
                </c:pt>
                <c:pt idx="113">
                  <c:v>42705</c:v>
                </c:pt>
                <c:pt idx="114">
                  <c:v>42706</c:v>
                </c:pt>
                <c:pt idx="115">
                  <c:v>42707</c:v>
                </c:pt>
                <c:pt idx="116">
                  <c:v>42708</c:v>
                </c:pt>
                <c:pt idx="117">
                  <c:v>42709</c:v>
                </c:pt>
                <c:pt idx="118">
                  <c:v>42710</c:v>
                </c:pt>
                <c:pt idx="119">
                  <c:v>42711</c:v>
                </c:pt>
                <c:pt idx="120">
                  <c:v>42712</c:v>
                </c:pt>
                <c:pt idx="121">
                  <c:v>42713</c:v>
                </c:pt>
                <c:pt idx="122">
                  <c:v>42714</c:v>
                </c:pt>
                <c:pt idx="123">
                  <c:v>42715</c:v>
                </c:pt>
                <c:pt idx="124">
                  <c:v>42716</c:v>
                </c:pt>
                <c:pt idx="125">
                  <c:v>42717</c:v>
                </c:pt>
                <c:pt idx="126">
                  <c:v>42718</c:v>
                </c:pt>
                <c:pt idx="127">
                  <c:v>42719</c:v>
                </c:pt>
                <c:pt idx="128">
                  <c:v>42720</c:v>
                </c:pt>
                <c:pt idx="129">
                  <c:v>42721</c:v>
                </c:pt>
                <c:pt idx="130">
                  <c:v>42722</c:v>
                </c:pt>
                <c:pt idx="131">
                  <c:v>42723</c:v>
                </c:pt>
                <c:pt idx="132">
                  <c:v>42724</c:v>
                </c:pt>
              </c:numCache>
            </c:numRef>
          </c:cat>
          <c:val>
            <c:numRef>
              <c:f>Sheet3!$B$2:$B$134</c:f>
              <c:numCache>
                <c:formatCode>0.00</c:formatCode>
                <c:ptCount val="133"/>
                <c:pt idx="0">
                  <c:v>77.597222222222229</c:v>
                </c:pt>
                <c:pt idx="1">
                  <c:v>72.9375</c:v>
                </c:pt>
                <c:pt idx="2">
                  <c:v>69.305555555555557</c:v>
                </c:pt>
                <c:pt idx="3">
                  <c:v>69.958333333333329</c:v>
                </c:pt>
                <c:pt idx="4">
                  <c:v>72.604166666666671</c:v>
                </c:pt>
                <c:pt idx="5">
                  <c:v>76.430555555555557</c:v>
                </c:pt>
                <c:pt idx="6">
                  <c:v>81.097222222222229</c:v>
                </c:pt>
                <c:pt idx="7">
                  <c:v>81.951388888888886</c:v>
                </c:pt>
                <c:pt idx="8">
                  <c:v>81.673611111111114</c:v>
                </c:pt>
                <c:pt idx="9">
                  <c:v>87.715277777777771</c:v>
                </c:pt>
                <c:pt idx="10">
                  <c:v>90.625</c:v>
                </c:pt>
                <c:pt idx="11">
                  <c:v>73.5</c:v>
                </c:pt>
                <c:pt idx="12">
                  <c:v>75.416666666666671</c:v>
                </c:pt>
                <c:pt idx="13">
                  <c:v>77.75</c:v>
                </c:pt>
                <c:pt idx="14">
                  <c:v>81.770833333333329</c:v>
                </c:pt>
                <c:pt idx="15">
                  <c:v>86.1875</c:v>
                </c:pt>
                <c:pt idx="16">
                  <c:v>80.972222222222229</c:v>
                </c:pt>
                <c:pt idx="17">
                  <c:v>81.486111111111114</c:v>
                </c:pt>
                <c:pt idx="18">
                  <c:v>82.263888888888886</c:v>
                </c:pt>
                <c:pt idx="19">
                  <c:v>85.472222222222229</c:v>
                </c:pt>
                <c:pt idx="20">
                  <c:v>74.493055555555557</c:v>
                </c:pt>
                <c:pt idx="21">
                  <c:v>72.847222222222229</c:v>
                </c:pt>
                <c:pt idx="22">
                  <c:v>73.784722222222229</c:v>
                </c:pt>
                <c:pt idx="23">
                  <c:v>76.763888888888886</c:v>
                </c:pt>
                <c:pt idx="24">
                  <c:v>78.125</c:v>
                </c:pt>
                <c:pt idx="25">
                  <c:v>81.791666666666671</c:v>
                </c:pt>
                <c:pt idx="26">
                  <c:v>88.784722222222229</c:v>
                </c:pt>
                <c:pt idx="27">
                  <c:v>105.07638888888889</c:v>
                </c:pt>
                <c:pt idx="28">
                  <c:v>122.72222222222223</c:v>
                </c:pt>
                <c:pt idx="29">
                  <c:v>152.85416666666666</c:v>
                </c:pt>
                <c:pt idx="30">
                  <c:v>165.65277777777777</c:v>
                </c:pt>
                <c:pt idx="31">
                  <c:v>155.65972222222223</c:v>
                </c:pt>
                <c:pt idx="32">
                  <c:v>159.63888888888889</c:v>
                </c:pt>
                <c:pt idx="33">
                  <c:v>174.70138888888889</c:v>
                </c:pt>
                <c:pt idx="34">
                  <c:v>188.11111111111111</c:v>
                </c:pt>
                <c:pt idx="35">
                  <c:v>181.66666666666666</c:v>
                </c:pt>
                <c:pt idx="36">
                  <c:v>72.888888888888886</c:v>
                </c:pt>
                <c:pt idx="37">
                  <c:v>70.041666666666671</c:v>
                </c:pt>
                <c:pt idx="38">
                  <c:v>73.409722222222229</c:v>
                </c:pt>
                <c:pt idx="39">
                  <c:v>79.826388888888886</c:v>
                </c:pt>
                <c:pt idx="40">
                  <c:v>86.75</c:v>
                </c:pt>
                <c:pt idx="41">
                  <c:v>98.270833333333329</c:v>
                </c:pt>
                <c:pt idx="42">
                  <c:v>114.76388888888889</c:v>
                </c:pt>
                <c:pt idx="43">
                  <c:v>139.64583333333334</c:v>
                </c:pt>
                <c:pt idx="44">
                  <c:v>132.64583333333334</c:v>
                </c:pt>
                <c:pt idx="45">
                  <c:v>130.74305555555554</c:v>
                </c:pt>
                <c:pt idx="46">
                  <c:v>141.81944444444446</c:v>
                </c:pt>
                <c:pt idx="47">
                  <c:v>175.53472222222223</c:v>
                </c:pt>
                <c:pt idx="48">
                  <c:v>239.98611111111111</c:v>
                </c:pt>
                <c:pt idx="49">
                  <c:v>300.33333333333331</c:v>
                </c:pt>
                <c:pt idx="50">
                  <c:v>203.35872758194188</c:v>
                </c:pt>
                <c:pt idx="51">
                  <c:v>291.8125</c:v>
                </c:pt>
                <c:pt idx="52">
                  <c:v>290.34027777777777</c:v>
                </c:pt>
                <c:pt idx="53">
                  <c:v>351.27083333333331</c:v>
                </c:pt>
                <c:pt idx="54">
                  <c:v>426.02083333333331</c:v>
                </c:pt>
                <c:pt idx="55">
                  <c:v>443.73611111111109</c:v>
                </c:pt>
                <c:pt idx="56">
                  <c:v>387.38888888888891</c:v>
                </c:pt>
                <c:pt idx="57">
                  <c:v>407.03472222222223</c:v>
                </c:pt>
                <c:pt idx="58">
                  <c:v>487.5</c:v>
                </c:pt>
                <c:pt idx="59">
                  <c:v>575.05555555555554</c:v>
                </c:pt>
                <c:pt idx="60">
                  <c:v>580.88888888888891</c:v>
                </c:pt>
                <c:pt idx="61">
                  <c:v>599.38194444444446</c:v>
                </c:pt>
                <c:pt idx="62">
                  <c:v>632.94444444444446</c:v>
                </c:pt>
                <c:pt idx="63">
                  <c:v>633</c:v>
                </c:pt>
                <c:pt idx="64">
                  <c:v>633</c:v>
                </c:pt>
                <c:pt idx="65">
                  <c:v>633</c:v>
                </c:pt>
                <c:pt idx="66">
                  <c:v>633</c:v>
                </c:pt>
                <c:pt idx="67">
                  <c:v>633</c:v>
                </c:pt>
                <c:pt idx="68">
                  <c:v>633</c:v>
                </c:pt>
                <c:pt idx="69">
                  <c:v>633</c:v>
                </c:pt>
                <c:pt idx="70">
                  <c:v>633</c:v>
                </c:pt>
                <c:pt idx="71">
                  <c:v>633</c:v>
                </c:pt>
                <c:pt idx="72">
                  <c:v>633</c:v>
                </c:pt>
                <c:pt idx="73">
                  <c:v>633</c:v>
                </c:pt>
                <c:pt idx="74">
                  <c:v>633</c:v>
                </c:pt>
                <c:pt idx="75">
                  <c:v>633</c:v>
                </c:pt>
                <c:pt idx="76">
                  <c:v>633</c:v>
                </c:pt>
                <c:pt idx="77">
                  <c:v>633</c:v>
                </c:pt>
                <c:pt idx="78">
                  <c:v>633</c:v>
                </c:pt>
                <c:pt idx="79">
                  <c:v>633</c:v>
                </c:pt>
                <c:pt idx="80">
                  <c:v>633</c:v>
                </c:pt>
                <c:pt idx="81">
                  <c:v>633</c:v>
                </c:pt>
                <c:pt idx="82">
                  <c:v>633</c:v>
                </c:pt>
                <c:pt idx="83">
                  <c:v>633</c:v>
                </c:pt>
                <c:pt idx="84">
                  <c:v>633</c:v>
                </c:pt>
                <c:pt idx="85">
                  <c:v>633</c:v>
                </c:pt>
                <c:pt idx="86">
                  <c:v>633</c:v>
                </c:pt>
                <c:pt idx="87">
                  <c:v>633</c:v>
                </c:pt>
                <c:pt idx="88">
                  <c:v>633</c:v>
                </c:pt>
                <c:pt idx="89">
                  <c:v>633</c:v>
                </c:pt>
                <c:pt idx="90">
                  <c:v>633</c:v>
                </c:pt>
                <c:pt idx="91">
                  <c:v>633</c:v>
                </c:pt>
                <c:pt idx="92">
                  <c:v>633</c:v>
                </c:pt>
                <c:pt idx="93">
                  <c:v>633</c:v>
                </c:pt>
                <c:pt idx="94">
                  <c:v>633</c:v>
                </c:pt>
                <c:pt idx="95">
                  <c:v>633</c:v>
                </c:pt>
                <c:pt idx="96">
                  <c:v>633</c:v>
                </c:pt>
                <c:pt idx="97">
                  <c:v>633</c:v>
                </c:pt>
                <c:pt idx="98">
                  <c:v>633</c:v>
                </c:pt>
                <c:pt idx="99">
                  <c:v>633</c:v>
                </c:pt>
                <c:pt idx="100">
                  <c:v>633</c:v>
                </c:pt>
                <c:pt idx="101">
                  <c:v>633</c:v>
                </c:pt>
                <c:pt idx="102">
                  <c:v>633</c:v>
                </c:pt>
                <c:pt idx="103">
                  <c:v>633</c:v>
                </c:pt>
                <c:pt idx="104">
                  <c:v>633</c:v>
                </c:pt>
                <c:pt idx="105">
                  <c:v>633</c:v>
                </c:pt>
                <c:pt idx="106">
                  <c:v>633</c:v>
                </c:pt>
                <c:pt idx="107">
                  <c:v>633</c:v>
                </c:pt>
                <c:pt idx="108">
                  <c:v>633</c:v>
                </c:pt>
                <c:pt idx="109">
                  <c:v>633</c:v>
                </c:pt>
                <c:pt idx="110">
                  <c:v>633</c:v>
                </c:pt>
                <c:pt idx="111">
                  <c:v>633</c:v>
                </c:pt>
                <c:pt idx="112">
                  <c:v>633</c:v>
                </c:pt>
                <c:pt idx="113">
                  <c:v>633</c:v>
                </c:pt>
                <c:pt idx="114">
                  <c:v>633</c:v>
                </c:pt>
                <c:pt idx="115">
                  <c:v>633</c:v>
                </c:pt>
                <c:pt idx="116">
                  <c:v>633</c:v>
                </c:pt>
                <c:pt idx="117">
                  <c:v>633</c:v>
                </c:pt>
                <c:pt idx="118">
                  <c:v>633</c:v>
                </c:pt>
                <c:pt idx="119">
                  <c:v>633</c:v>
                </c:pt>
                <c:pt idx="120">
                  <c:v>633</c:v>
                </c:pt>
                <c:pt idx="121">
                  <c:v>633</c:v>
                </c:pt>
                <c:pt idx="122">
                  <c:v>633</c:v>
                </c:pt>
                <c:pt idx="123">
                  <c:v>633</c:v>
                </c:pt>
                <c:pt idx="124">
                  <c:v>633</c:v>
                </c:pt>
                <c:pt idx="125">
                  <c:v>633</c:v>
                </c:pt>
                <c:pt idx="126">
                  <c:v>633</c:v>
                </c:pt>
                <c:pt idx="127">
                  <c:v>633</c:v>
                </c:pt>
                <c:pt idx="128">
                  <c:v>633</c:v>
                </c:pt>
                <c:pt idx="129">
                  <c:v>633</c:v>
                </c:pt>
                <c:pt idx="130">
                  <c:v>633</c:v>
                </c:pt>
                <c:pt idx="131">
                  <c:v>633</c:v>
                </c:pt>
                <c:pt idx="132">
                  <c:v>6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101-8745-B760-0A032D8E2A57}"/>
            </c:ext>
          </c:extLst>
        </c:ser>
        <c:ser>
          <c:idx val="1"/>
          <c:order val="1"/>
          <c:tx>
            <c:strRef>
              <c:f>Sheet3!$C$1</c:f>
              <c:strCache>
                <c:ptCount val="1"/>
                <c:pt idx="0">
                  <c:v>Soil-water-tension(Kpa)_40 cM</c:v>
                </c:pt>
              </c:strCache>
            </c:strRef>
          </c:tx>
          <c:spPr>
            <a:ln w="28575" cap="rnd">
              <a:solidFill>
                <a:srgbClr val="FFC000"/>
              </a:solidFill>
              <a:round/>
            </a:ln>
            <a:effectLst/>
          </c:spPr>
          <c:marker>
            <c:symbol val="none"/>
          </c:marker>
          <c:cat>
            <c:numRef>
              <c:f>Sheet3!$A$2:$A$134</c:f>
              <c:numCache>
                <c:formatCode>m/d/yyyy</c:formatCode>
                <c:ptCount val="133"/>
                <c:pt idx="0">
                  <c:v>42592</c:v>
                </c:pt>
                <c:pt idx="1">
                  <c:v>42593</c:v>
                </c:pt>
                <c:pt idx="2">
                  <c:v>42594</c:v>
                </c:pt>
                <c:pt idx="3">
                  <c:v>42595</c:v>
                </c:pt>
                <c:pt idx="4">
                  <c:v>42596</c:v>
                </c:pt>
                <c:pt idx="5">
                  <c:v>42597</c:v>
                </c:pt>
                <c:pt idx="6">
                  <c:v>42598</c:v>
                </c:pt>
                <c:pt idx="7">
                  <c:v>42599</c:v>
                </c:pt>
                <c:pt idx="8">
                  <c:v>42600</c:v>
                </c:pt>
                <c:pt idx="9">
                  <c:v>42601</c:v>
                </c:pt>
                <c:pt idx="10">
                  <c:v>42602</c:v>
                </c:pt>
                <c:pt idx="11">
                  <c:v>42603</c:v>
                </c:pt>
                <c:pt idx="12">
                  <c:v>42604</c:v>
                </c:pt>
                <c:pt idx="13">
                  <c:v>42605</c:v>
                </c:pt>
                <c:pt idx="14">
                  <c:v>42606</c:v>
                </c:pt>
                <c:pt idx="15">
                  <c:v>42607</c:v>
                </c:pt>
                <c:pt idx="16">
                  <c:v>42608</c:v>
                </c:pt>
                <c:pt idx="17">
                  <c:v>42609</c:v>
                </c:pt>
                <c:pt idx="18">
                  <c:v>42610</c:v>
                </c:pt>
                <c:pt idx="19">
                  <c:v>42611</c:v>
                </c:pt>
                <c:pt idx="20">
                  <c:v>42612</c:v>
                </c:pt>
                <c:pt idx="21">
                  <c:v>42613</c:v>
                </c:pt>
                <c:pt idx="22">
                  <c:v>42614</c:v>
                </c:pt>
                <c:pt idx="23">
                  <c:v>42615</c:v>
                </c:pt>
                <c:pt idx="24">
                  <c:v>42616</c:v>
                </c:pt>
                <c:pt idx="25">
                  <c:v>42617</c:v>
                </c:pt>
                <c:pt idx="26">
                  <c:v>42618</c:v>
                </c:pt>
                <c:pt idx="27">
                  <c:v>42619</c:v>
                </c:pt>
                <c:pt idx="28">
                  <c:v>42620</c:v>
                </c:pt>
                <c:pt idx="29">
                  <c:v>42621</c:v>
                </c:pt>
                <c:pt idx="30">
                  <c:v>42622</c:v>
                </c:pt>
                <c:pt idx="31">
                  <c:v>42623</c:v>
                </c:pt>
                <c:pt idx="32">
                  <c:v>42624</c:v>
                </c:pt>
                <c:pt idx="33">
                  <c:v>42625</c:v>
                </c:pt>
                <c:pt idx="34">
                  <c:v>42626</c:v>
                </c:pt>
                <c:pt idx="35">
                  <c:v>42627</c:v>
                </c:pt>
                <c:pt idx="36">
                  <c:v>42628</c:v>
                </c:pt>
                <c:pt idx="37">
                  <c:v>42629</c:v>
                </c:pt>
                <c:pt idx="38">
                  <c:v>42630</c:v>
                </c:pt>
                <c:pt idx="39">
                  <c:v>42631</c:v>
                </c:pt>
                <c:pt idx="40">
                  <c:v>42632</c:v>
                </c:pt>
                <c:pt idx="41">
                  <c:v>42633</c:v>
                </c:pt>
                <c:pt idx="42">
                  <c:v>42634</c:v>
                </c:pt>
                <c:pt idx="43">
                  <c:v>42635</c:v>
                </c:pt>
                <c:pt idx="44">
                  <c:v>42636</c:v>
                </c:pt>
                <c:pt idx="45">
                  <c:v>42637</c:v>
                </c:pt>
                <c:pt idx="46">
                  <c:v>42638</c:v>
                </c:pt>
                <c:pt idx="47">
                  <c:v>42639</c:v>
                </c:pt>
                <c:pt idx="48">
                  <c:v>42640</c:v>
                </c:pt>
                <c:pt idx="49">
                  <c:v>42641</c:v>
                </c:pt>
                <c:pt idx="50">
                  <c:v>42642</c:v>
                </c:pt>
                <c:pt idx="51">
                  <c:v>42643</c:v>
                </c:pt>
                <c:pt idx="52">
                  <c:v>42644</c:v>
                </c:pt>
                <c:pt idx="53">
                  <c:v>42645</c:v>
                </c:pt>
                <c:pt idx="54">
                  <c:v>42646</c:v>
                </c:pt>
                <c:pt idx="55">
                  <c:v>42647</c:v>
                </c:pt>
                <c:pt idx="56">
                  <c:v>42648</c:v>
                </c:pt>
                <c:pt idx="57">
                  <c:v>42649</c:v>
                </c:pt>
                <c:pt idx="58">
                  <c:v>42650</c:v>
                </c:pt>
                <c:pt idx="59">
                  <c:v>42651</c:v>
                </c:pt>
                <c:pt idx="60">
                  <c:v>42652</c:v>
                </c:pt>
                <c:pt idx="61">
                  <c:v>42653</c:v>
                </c:pt>
                <c:pt idx="62">
                  <c:v>42654</c:v>
                </c:pt>
                <c:pt idx="63">
                  <c:v>42655</c:v>
                </c:pt>
                <c:pt idx="64">
                  <c:v>42656</c:v>
                </c:pt>
                <c:pt idx="65">
                  <c:v>42657</c:v>
                </c:pt>
                <c:pt idx="66">
                  <c:v>42658</c:v>
                </c:pt>
                <c:pt idx="67">
                  <c:v>42659</c:v>
                </c:pt>
                <c:pt idx="68">
                  <c:v>42660</c:v>
                </c:pt>
                <c:pt idx="69">
                  <c:v>42661</c:v>
                </c:pt>
                <c:pt idx="70">
                  <c:v>42662</c:v>
                </c:pt>
                <c:pt idx="71">
                  <c:v>42663</c:v>
                </c:pt>
                <c:pt idx="72">
                  <c:v>42664</c:v>
                </c:pt>
                <c:pt idx="73">
                  <c:v>42665</c:v>
                </c:pt>
                <c:pt idx="74">
                  <c:v>42666</c:v>
                </c:pt>
                <c:pt idx="75">
                  <c:v>42667</c:v>
                </c:pt>
                <c:pt idx="76">
                  <c:v>42668</c:v>
                </c:pt>
                <c:pt idx="77">
                  <c:v>42669</c:v>
                </c:pt>
                <c:pt idx="78">
                  <c:v>42670</c:v>
                </c:pt>
                <c:pt idx="79">
                  <c:v>42671</c:v>
                </c:pt>
                <c:pt idx="80">
                  <c:v>42672</c:v>
                </c:pt>
                <c:pt idx="81">
                  <c:v>42673</c:v>
                </c:pt>
                <c:pt idx="82">
                  <c:v>42674</c:v>
                </c:pt>
                <c:pt idx="83">
                  <c:v>42675</c:v>
                </c:pt>
                <c:pt idx="84">
                  <c:v>42676</c:v>
                </c:pt>
                <c:pt idx="85">
                  <c:v>42677</c:v>
                </c:pt>
                <c:pt idx="86">
                  <c:v>42678</c:v>
                </c:pt>
                <c:pt idx="87">
                  <c:v>42679</c:v>
                </c:pt>
                <c:pt idx="88">
                  <c:v>42680</c:v>
                </c:pt>
                <c:pt idx="89">
                  <c:v>42681</c:v>
                </c:pt>
                <c:pt idx="90">
                  <c:v>42682</c:v>
                </c:pt>
                <c:pt idx="91">
                  <c:v>42683</c:v>
                </c:pt>
                <c:pt idx="92">
                  <c:v>42684</c:v>
                </c:pt>
                <c:pt idx="93">
                  <c:v>42685</c:v>
                </c:pt>
                <c:pt idx="94">
                  <c:v>42686</c:v>
                </c:pt>
                <c:pt idx="95">
                  <c:v>42687</c:v>
                </c:pt>
                <c:pt idx="96">
                  <c:v>42688</c:v>
                </c:pt>
                <c:pt idx="97">
                  <c:v>42689</c:v>
                </c:pt>
                <c:pt idx="98">
                  <c:v>42690</c:v>
                </c:pt>
                <c:pt idx="99">
                  <c:v>42691</c:v>
                </c:pt>
                <c:pt idx="100">
                  <c:v>42692</c:v>
                </c:pt>
                <c:pt idx="101">
                  <c:v>42693</c:v>
                </c:pt>
                <c:pt idx="102">
                  <c:v>42694</c:v>
                </c:pt>
                <c:pt idx="103">
                  <c:v>42695</c:v>
                </c:pt>
                <c:pt idx="104">
                  <c:v>42696</c:v>
                </c:pt>
                <c:pt idx="105">
                  <c:v>42697</c:v>
                </c:pt>
                <c:pt idx="106">
                  <c:v>42698</c:v>
                </c:pt>
                <c:pt idx="107">
                  <c:v>42699</c:v>
                </c:pt>
                <c:pt idx="108">
                  <c:v>42700</c:v>
                </c:pt>
                <c:pt idx="109">
                  <c:v>42701</c:v>
                </c:pt>
                <c:pt idx="110">
                  <c:v>42702</c:v>
                </c:pt>
                <c:pt idx="111">
                  <c:v>42703</c:v>
                </c:pt>
                <c:pt idx="112">
                  <c:v>42704</c:v>
                </c:pt>
                <c:pt idx="113">
                  <c:v>42705</c:v>
                </c:pt>
                <c:pt idx="114">
                  <c:v>42706</c:v>
                </c:pt>
                <c:pt idx="115">
                  <c:v>42707</c:v>
                </c:pt>
                <c:pt idx="116">
                  <c:v>42708</c:v>
                </c:pt>
                <c:pt idx="117">
                  <c:v>42709</c:v>
                </c:pt>
                <c:pt idx="118">
                  <c:v>42710</c:v>
                </c:pt>
                <c:pt idx="119">
                  <c:v>42711</c:v>
                </c:pt>
                <c:pt idx="120">
                  <c:v>42712</c:v>
                </c:pt>
                <c:pt idx="121">
                  <c:v>42713</c:v>
                </c:pt>
                <c:pt idx="122">
                  <c:v>42714</c:v>
                </c:pt>
                <c:pt idx="123">
                  <c:v>42715</c:v>
                </c:pt>
                <c:pt idx="124">
                  <c:v>42716</c:v>
                </c:pt>
                <c:pt idx="125">
                  <c:v>42717</c:v>
                </c:pt>
                <c:pt idx="126">
                  <c:v>42718</c:v>
                </c:pt>
                <c:pt idx="127">
                  <c:v>42719</c:v>
                </c:pt>
                <c:pt idx="128">
                  <c:v>42720</c:v>
                </c:pt>
                <c:pt idx="129">
                  <c:v>42721</c:v>
                </c:pt>
                <c:pt idx="130">
                  <c:v>42722</c:v>
                </c:pt>
                <c:pt idx="131">
                  <c:v>42723</c:v>
                </c:pt>
                <c:pt idx="132">
                  <c:v>42724</c:v>
                </c:pt>
              </c:numCache>
            </c:numRef>
          </c:cat>
          <c:val>
            <c:numRef>
              <c:f>Sheet3!$C$2:$C$134</c:f>
              <c:numCache>
                <c:formatCode>0.00</c:formatCode>
                <c:ptCount val="133"/>
                <c:pt idx="0">
                  <c:v>47.541666666666664</c:v>
                </c:pt>
                <c:pt idx="1">
                  <c:v>48.305555555555557</c:v>
                </c:pt>
                <c:pt idx="2">
                  <c:v>50.555555555555557</c:v>
                </c:pt>
                <c:pt idx="3">
                  <c:v>50</c:v>
                </c:pt>
                <c:pt idx="4">
                  <c:v>49.520833333333336</c:v>
                </c:pt>
                <c:pt idx="5">
                  <c:v>49.979166666666664</c:v>
                </c:pt>
                <c:pt idx="6">
                  <c:v>51.083333333333336</c:v>
                </c:pt>
                <c:pt idx="7">
                  <c:v>50.631944444444443</c:v>
                </c:pt>
                <c:pt idx="8">
                  <c:v>50.319444444444443</c:v>
                </c:pt>
                <c:pt idx="9">
                  <c:v>54.256944444444443</c:v>
                </c:pt>
                <c:pt idx="10">
                  <c:v>57.569444444444443</c:v>
                </c:pt>
                <c:pt idx="11">
                  <c:v>60.777777777777779</c:v>
                </c:pt>
                <c:pt idx="12">
                  <c:v>64.243055555555557</c:v>
                </c:pt>
                <c:pt idx="13">
                  <c:v>68.25</c:v>
                </c:pt>
                <c:pt idx="14">
                  <c:v>72.236111111111114</c:v>
                </c:pt>
                <c:pt idx="15">
                  <c:v>76.944444444444443</c:v>
                </c:pt>
                <c:pt idx="16">
                  <c:v>81.75</c:v>
                </c:pt>
                <c:pt idx="17">
                  <c:v>87.423611111111114</c:v>
                </c:pt>
                <c:pt idx="18">
                  <c:v>92.430555555555557</c:v>
                </c:pt>
                <c:pt idx="19">
                  <c:v>96.222222222222229</c:v>
                </c:pt>
                <c:pt idx="20">
                  <c:v>100.49305555555556</c:v>
                </c:pt>
                <c:pt idx="21">
                  <c:v>105.20138888888889</c:v>
                </c:pt>
                <c:pt idx="22">
                  <c:v>110.11805555555556</c:v>
                </c:pt>
                <c:pt idx="23">
                  <c:v>114.90277777777777</c:v>
                </c:pt>
                <c:pt idx="24">
                  <c:v>119.34027777777777</c:v>
                </c:pt>
                <c:pt idx="25">
                  <c:v>124.13194444444444</c:v>
                </c:pt>
                <c:pt idx="26">
                  <c:v>128.25694444444446</c:v>
                </c:pt>
                <c:pt idx="27">
                  <c:v>119.74305555555556</c:v>
                </c:pt>
                <c:pt idx="28">
                  <c:v>104.86805555555556</c:v>
                </c:pt>
                <c:pt idx="29">
                  <c:v>116.85416666666667</c:v>
                </c:pt>
                <c:pt idx="30">
                  <c:v>125.61805555555556</c:v>
                </c:pt>
                <c:pt idx="31">
                  <c:v>130.9375</c:v>
                </c:pt>
                <c:pt idx="32">
                  <c:v>135.125</c:v>
                </c:pt>
                <c:pt idx="33">
                  <c:v>136.75</c:v>
                </c:pt>
                <c:pt idx="34">
                  <c:v>141.21527777777777</c:v>
                </c:pt>
                <c:pt idx="35">
                  <c:v>144.23611111111111</c:v>
                </c:pt>
                <c:pt idx="36">
                  <c:v>147.3125</c:v>
                </c:pt>
                <c:pt idx="37">
                  <c:v>147.79166666666666</c:v>
                </c:pt>
                <c:pt idx="38">
                  <c:v>147.06944444444446</c:v>
                </c:pt>
                <c:pt idx="39">
                  <c:v>147.22916666666666</c:v>
                </c:pt>
                <c:pt idx="40">
                  <c:v>149.64583333333334</c:v>
                </c:pt>
                <c:pt idx="41">
                  <c:v>150.61805555555554</c:v>
                </c:pt>
                <c:pt idx="42">
                  <c:v>150.22222222222223</c:v>
                </c:pt>
                <c:pt idx="43">
                  <c:v>151.14583333333334</c:v>
                </c:pt>
                <c:pt idx="44">
                  <c:v>151.59722222222223</c:v>
                </c:pt>
                <c:pt idx="45">
                  <c:v>148.89583333333334</c:v>
                </c:pt>
                <c:pt idx="46">
                  <c:v>149.1875</c:v>
                </c:pt>
                <c:pt idx="47">
                  <c:v>149.39583333333334</c:v>
                </c:pt>
                <c:pt idx="48">
                  <c:v>149.74305555555554</c:v>
                </c:pt>
                <c:pt idx="49">
                  <c:v>149.38888888888889</c:v>
                </c:pt>
                <c:pt idx="50">
                  <c:v>143.23316713048857</c:v>
                </c:pt>
                <c:pt idx="51">
                  <c:v>59.680555555555557</c:v>
                </c:pt>
                <c:pt idx="52">
                  <c:v>69.145833333333329</c:v>
                </c:pt>
                <c:pt idx="53">
                  <c:v>77.354166666666671</c:v>
                </c:pt>
                <c:pt idx="54">
                  <c:v>85.604166666666671</c:v>
                </c:pt>
                <c:pt idx="55">
                  <c:v>94.111111111111114</c:v>
                </c:pt>
                <c:pt idx="56">
                  <c:v>101.56944444444444</c:v>
                </c:pt>
                <c:pt idx="57">
                  <c:v>107.44444444444444</c:v>
                </c:pt>
                <c:pt idx="58">
                  <c:v>110.29166666666667</c:v>
                </c:pt>
                <c:pt idx="59">
                  <c:v>112.88888888888889</c:v>
                </c:pt>
                <c:pt idx="60">
                  <c:v>113.79166666666667</c:v>
                </c:pt>
                <c:pt idx="61">
                  <c:v>117.44444444444444</c:v>
                </c:pt>
                <c:pt idx="62">
                  <c:v>122.69444444444444</c:v>
                </c:pt>
                <c:pt idx="63">
                  <c:v>127.71527777777777</c:v>
                </c:pt>
                <c:pt idx="64">
                  <c:v>133.46527777777777</c:v>
                </c:pt>
                <c:pt idx="65">
                  <c:v>137.38194444444446</c:v>
                </c:pt>
                <c:pt idx="66">
                  <c:v>140.61805555555554</c:v>
                </c:pt>
                <c:pt idx="67">
                  <c:v>145.93055555555554</c:v>
                </c:pt>
                <c:pt idx="68">
                  <c:v>159.27083333333334</c:v>
                </c:pt>
                <c:pt idx="69">
                  <c:v>172.93055555555554</c:v>
                </c:pt>
                <c:pt idx="70">
                  <c:v>186.27777777777777</c:v>
                </c:pt>
                <c:pt idx="71">
                  <c:v>196.86805555555554</c:v>
                </c:pt>
                <c:pt idx="72">
                  <c:v>203.36805555555554</c:v>
                </c:pt>
                <c:pt idx="73">
                  <c:v>220.64583333333334</c:v>
                </c:pt>
                <c:pt idx="74">
                  <c:v>241.90972222222223</c:v>
                </c:pt>
                <c:pt idx="75">
                  <c:v>263.29861111111109</c:v>
                </c:pt>
                <c:pt idx="76">
                  <c:v>281.02083333333331</c:v>
                </c:pt>
                <c:pt idx="77">
                  <c:v>298.54861111111109</c:v>
                </c:pt>
                <c:pt idx="78">
                  <c:v>323.95138888888891</c:v>
                </c:pt>
                <c:pt idx="79">
                  <c:v>351.125</c:v>
                </c:pt>
                <c:pt idx="80">
                  <c:v>376.02083333333331</c:v>
                </c:pt>
                <c:pt idx="81">
                  <c:v>392.79166666666669</c:v>
                </c:pt>
                <c:pt idx="82">
                  <c:v>431.21527777777777</c:v>
                </c:pt>
                <c:pt idx="83">
                  <c:v>466.29166666666669</c:v>
                </c:pt>
                <c:pt idx="84">
                  <c:v>496.63194444444446</c:v>
                </c:pt>
                <c:pt idx="85">
                  <c:v>519.00694444444446</c:v>
                </c:pt>
                <c:pt idx="86">
                  <c:v>535.04861111111109</c:v>
                </c:pt>
                <c:pt idx="87">
                  <c:v>551.86805555555554</c:v>
                </c:pt>
                <c:pt idx="88">
                  <c:v>576.30555555555554</c:v>
                </c:pt>
                <c:pt idx="89">
                  <c:v>599.68055555555554</c:v>
                </c:pt>
                <c:pt idx="90">
                  <c:v>620.61805555555554</c:v>
                </c:pt>
                <c:pt idx="91">
                  <c:v>631.83333333333337</c:v>
                </c:pt>
                <c:pt idx="92">
                  <c:v>632.92361111111109</c:v>
                </c:pt>
                <c:pt idx="93">
                  <c:v>633</c:v>
                </c:pt>
                <c:pt idx="94">
                  <c:v>633</c:v>
                </c:pt>
                <c:pt idx="95">
                  <c:v>633</c:v>
                </c:pt>
                <c:pt idx="96">
                  <c:v>633</c:v>
                </c:pt>
                <c:pt idx="97">
                  <c:v>633</c:v>
                </c:pt>
                <c:pt idx="98">
                  <c:v>633</c:v>
                </c:pt>
                <c:pt idx="99">
                  <c:v>633</c:v>
                </c:pt>
                <c:pt idx="100">
                  <c:v>633</c:v>
                </c:pt>
                <c:pt idx="101">
                  <c:v>633</c:v>
                </c:pt>
                <c:pt idx="102">
                  <c:v>633</c:v>
                </c:pt>
                <c:pt idx="103">
                  <c:v>633</c:v>
                </c:pt>
                <c:pt idx="104">
                  <c:v>633</c:v>
                </c:pt>
                <c:pt idx="105">
                  <c:v>633</c:v>
                </c:pt>
                <c:pt idx="106">
                  <c:v>633</c:v>
                </c:pt>
                <c:pt idx="107">
                  <c:v>633</c:v>
                </c:pt>
                <c:pt idx="108">
                  <c:v>633</c:v>
                </c:pt>
                <c:pt idx="109">
                  <c:v>633</c:v>
                </c:pt>
                <c:pt idx="110">
                  <c:v>633</c:v>
                </c:pt>
                <c:pt idx="111">
                  <c:v>633</c:v>
                </c:pt>
                <c:pt idx="112">
                  <c:v>633</c:v>
                </c:pt>
                <c:pt idx="113">
                  <c:v>633</c:v>
                </c:pt>
                <c:pt idx="114">
                  <c:v>633</c:v>
                </c:pt>
                <c:pt idx="115">
                  <c:v>633</c:v>
                </c:pt>
                <c:pt idx="116">
                  <c:v>633</c:v>
                </c:pt>
                <c:pt idx="117">
                  <c:v>633</c:v>
                </c:pt>
                <c:pt idx="118">
                  <c:v>633</c:v>
                </c:pt>
                <c:pt idx="119">
                  <c:v>633</c:v>
                </c:pt>
                <c:pt idx="120">
                  <c:v>633</c:v>
                </c:pt>
                <c:pt idx="121">
                  <c:v>633</c:v>
                </c:pt>
                <c:pt idx="122">
                  <c:v>633</c:v>
                </c:pt>
                <c:pt idx="123">
                  <c:v>633</c:v>
                </c:pt>
                <c:pt idx="124">
                  <c:v>633</c:v>
                </c:pt>
                <c:pt idx="125">
                  <c:v>633</c:v>
                </c:pt>
                <c:pt idx="126">
                  <c:v>633</c:v>
                </c:pt>
                <c:pt idx="127">
                  <c:v>633</c:v>
                </c:pt>
                <c:pt idx="128">
                  <c:v>633</c:v>
                </c:pt>
                <c:pt idx="129">
                  <c:v>633</c:v>
                </c:pt>
                <c:pt idx="130">
                  <c:v>633</c:v>
                </c:pt>
                <c:pt idx="131">
                  <c:v>633</c:v>
                </c:pt>
                <c:pt idx="132">
                  <c:v>6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101-8745-B760-0A032D8E2A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675653200"/>
        <c:axId val="-675652656"/>
      </c:lineChart>
      <c:lineChart>
        <c:grouping val="standard"/>
        <c:varyColors val="0"/>
        <c:ser>
          <c:idx val="6"/>
          <c:order val="2"/>
          <c:tx>
            <c:strRef>
              <c:f>Sheet3!$H$1</c:f>
              <c:strCache>
                <c:ptCount val="1"/>
                <c:pt idx="0">
                  <c:v>Max. temp (0C)</c:v>
                </c:pt>
              </c:strCache>
            </c:strRef>
          </c:tx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cat>
            <c:numRef>
              <c:f>Sheet3!$A$2:$A$134</c:f>
              <c:numCache>
                <c:formatCode>m/d/yyyy</c:formatCode>
                <c:ptCount val="133"/>
                <c:pt idx="0">
                  <c:v>42592</c:v>
                </c:pt>
                <c:pt idx="1">
                  <c:v>42593</c:v>
                </c:pt>
                <c:pt idx="2">
                  <c:v>42594</c:v>
                </c:pt>
                <c:pt idx="3">
                  <c:v>42595</c:v>
                </c:pt>
                <c:pt idx="4">
                  <c:v>42596</c:v>
                </c:pt>
                <c:pt idx="5">
                  <c:v>42597</c:v>
                </c:pt>
                <c:pt idx="6">
                  <c:v>42598</c:v>
                </c:pt>
                <c:pt idx="7">
                  <c:v>42599</c:v>
                </c:pt>
                <c:pt idx="8">
                  <c:v>42600</c:v>
                </c:pt>
                <c:pt idx="9">
                  <c:v>42601</c:v>
                </c:pt>
                <c:pt idx="10">
                  <c:v>42602</c:v>
                </c:pt>
                <c:pt idx="11">
                  <c:v>42603</c:v>
                </c:pt>
                <c:pt idx="12">
                  <c:v>42604</c:v>
                </c:pt>
                <c:pt idx="13">
                  <c:v>42605</c:v>
                </c:pt>
                <c:pt idx="14">
                  <c:v>42606</c:v>
                </c:pt>
                <c:pt idx="15">
                  <c:v>42607</c:v>
                </c:pt>
                <c:pt idx="16">
                  <c:v>42608</c:v>
                </c:pt>
                <c:pt idx="17">
                  <c:v>42609</c:v>
                </c:pt>
                <c:pt idx="18">
                  <c:v>42610</c:v>
                </c:pt>
                <c:pt idx="19">
                  <c:v>42611</c:v>
                </c:pt>
                <c:pt idx="20">
                  <c:v>42612</c:v>
                </c:pt>
                <c:pt idx="21">
                  <c:v>42613</c:v>
                </c:pt>
                <c:pt idx="22">
                  <c:v>42614</c:v>
                </c:pt>
                <c:pt idx="23">
                  <c:v>42615</c:v>
                </c:pt>
                <c:pt idx="24">
                  <c:v>42616</c:v>
                </c:pt>
                <c:pt idx="25">
                  <c:v>42617</c:v>
                </c:pt>
                <c:pt idx="26">
                  <c:v>42618</c:v>
                </c:pt>
                <c:pt idx="27">
                  <c:v>42619</c:v>
                </c:pt>
                <c:pt idx="28">
                  <c:v>42620</c:v>
                </c:pt>
                <c:pt idx="29">
                  <c:v>42621</c:v>
                </c:pt>
                <c:pt idx="30">
                  <c:v>42622</c:v>
                </c:pt>
                <c:pt idx="31">
                  <c:v>42623</c:v>
                </c:pt>
                <c:pt idx="32">
                  <c:v>42624</c:v>
                </c:pt>
                <c:pt idx="33">
                  <c:v>42625</c:v>
                </c:pt>
                <c:pt idx="34">
                  <c:v>42626</c:v>
                </c:pt>
                <c:pt idx="35">
                  <c:v>42627</c:v>
                </c:pt>
                <c:pt idx="36">
                  <c:v>42628</c:v>
                </c:pt>
                <c:pt idx="37">
                  <c:v>42629</c:v>
                </c:pt>
                <c:pt idx="38">
                  <c:v>42630</c:v>
                </c:pt>
                <c:pt idx="39">
                  <c:v>42631</c:v>
                </c:pt>
                <c:pt idx="40">
                  <c:v>42632</c:v>
                </c:pt>
                <c:pt idx="41">
                  <c:v>42633</c:v>
                </c:pt>
                <c:pt idx="42">
                  <c:v>42634</c:v>
                </c:pt>
                <c:pt idx="43">
                  <c:v>42635</c:v>
                </c:pt>
                <c:pt idx="44">
                  <c:v>42636</c:v>
                </c:pt>
                <c:pt idx="45">
                  <c:v>42637</c:v>
                </c:pt>
                <c:pt idx="46">
                  <c:v>42638</c:v>
                </c:pt>
                <c:pt idx="47">
                  <c:v>42639</c:v>
                </c:pt>
                <c:pt idx="48">
                  <c:v>42640</c:v>
                </c:pt>
                <c:pt idx="49">
                  <c:v>42641</c:v>
                </c:pt>
                <c:pt idx="50">
                  <c:v>42642</c:v>
                </c:pt>
                <c:pt idx="51">
                  <c:v>42643</c:v>
                </c:pt>
                <c:pt idx="52">
                  <c:v>42644</c:v>
                </c:pt>
                <c:pt idx="53">
                  <c:v>42645</c:v>
                </c:pt>
                <c:pt idx="54">
                  <c:v>42646</c:v>
                </c:pt>
                <c:pt idx="55">
                  <c:v>42647</c:v>
                </c:pt>
                <c:pt idx="56">
                  <c:v>42648</c:v>
                </c:pt>
                <c:pt idx="57">
                  <c:v>42649</c:v>
                </c:pt>
                <c:pt idx="58">
                  <c:v>42650</c:v>
                </c:pt>
                <c:pt idx="59">
                  <c:v>42651</c:v>
                </c:pt>
                <c:pt idx="60">
                  <c:v>42652</c:v>
                </c:pt>
                <c:pt idx="61">
                  <c:v>42653</c:v>
                </c:pt>
                <c:pt idx="62">
                  <c:v>42654</c:v>
                </c:pt>
                <c:pt idx="63">
                  <c:v>42655</c:v>
                </c:pt>
                <c:pt idx="64">
                  <c:v>42656</c:v>
                </c:pt>
                <c:pt idx="65">
                  <c:v>42657</c:v>
                </c:pt>
                <c:pt idx="66">
                  <c:v>42658</c:v>
                </c:pt>
                <c:pt idx="67">
                  <c:v>42659</c:v>
                </c:pt>
                <c:pt idx="68">
                  <c:v>42660</c:v>
                </c:pt>
                <c:pt idx="69">
                  <c:v>42661</c:v>
                </c:pt>
                <c:pt idx="70">
                  <c:v>42662</c:v>
                </c:pt>
                <c:pt idx="71">
                  <c:v>42663</c:v>
                </c:pt>
                <c:pt idx="72">
                  <c:v>42664</c:v>
                </c:pt>
                <c:pt idx="73">
                  <c:v>42665</c:v>
                </c:pt>
                <c:pt idx="74">
                  <c:v>42666</c:v>
                </c:pt>
                <c:pt idx="75">
                  <c:v>42667</c:v>
                </c:pt>
                <c:pt idx="76">
                  <c:v>42668</c:v>
                </c:pt>
                <c:pt idx="77">
                  <c:v>42669</c:v>
                </c:pt>
                <c:pt idx="78">
                  <c:v>42670</c:v>
                </c:pt>
                <c:pt idx="79">
                  <c:v>42671</c:v>
                </c:pt>
                <c:pt idx="80">
                  <c:v>42672</c:v>
                </c:pt>
                <c:pt idx="81">
                  <c:v>42673</c:v>
                </c:pt>
                <c:pt idx="82">
                  <c:v>42674</c:v>
                </c:pt>
                <c:pt idx="83">
                  <c:v>42675</c:v>
                </c:pt>
                <c:pt idx="84">
                  <c:v>42676</c:v>
                </c:pt>
                <c:pt idx="85">
                  <c:v>42677</c:v>
                </c:pt>
                <c:pt idx="86">
                  <c:v>42678</c:v>
                </c:pt>
                <c:pt idx="87">
                  <c:v>42679</c:v>
                </c:pt>
                <c:pt idx="88">
                  <c:v>42680</c:v>
                </c:pt>
                <c:pt idx="89">
                  <c:v>42681</c:v>
                </c:pt>
                <c:pt idx="90">
                  <c:v>42682</c:v>
                </c:pt>
                <c:pt idx="91">
                  <c:v>42683</c:v>
                </c:pt>
                <c:pt idx="92">
                  <c:v>42684</c:v>
                </c:pt>
                <c:pt idx="93">
                  <c:v>42685</c:v>
                </c:pt>
                <c:pt idx="94">
                  <c:v>42686</c:v>
                </c:pt>
                <c:pt idx="95">
                  <c:v>42687</c:v>
                </c:pt>
                <c:pt idx="96">
                  <c:v>42688</c:v>
                </c:pt>
                <c:pt idx="97">
                  <c:v>42689</c:v>
                </c:pt>
                <c:pt idx="98">
                  <c:v>42690</c:v>
                </c:pt>
                <c:pt idx="99">
                  <c:v>42691</c:v>
                </c:pt>
                <c:pt idx="100">
                  <c:v>42692</c:v>
                </c:pt>
                <c:pt idx="101">
                  <c:v>42693</c:v>
                </c:pt>
                <c:pt idx="102">
                  <c:v>42694</c:v>
                </c:pt>
                <c:pt idx="103">
                  <c:v>42695</c:v>
                </c:pt>
                <c:pt idx="104">
                  <c:v>42696</c:v>
                </c:pt>
                <c:pt idx="105">
                  <c:v>42697</c:v>
                </c:pt>
                <c:pt idx="106">
                  <c:v>42698</c:v>
                </c:pt>
                <c:pt idx="107">
                  <c:v>42699</c:v>
                </c:pt>
                <c:pt idx="108">
                  <c:v>42700</c:v>
                </c:pt>
                <c:pt idx="109">
                  <c:v>42701</c:v>
                </c:pt>
                <c:pt idx="110">
                  <c:v>42702</c:v>
                </c:pt>
                <c:pt idx="111">
                  <c:v>42703</c:v>
                </c:pt>
                <c:pt idx="112">
                  <c:v>42704</c:v>
                </c:pt>
                <c:pt idx="113">
                  <c:v>42705</c:v>
                </c:pt>
                <c:pt idx="114">
                  <c:v>42706</c:v>
                </c:pt>
                <c:pt idx="115">
                  <c:v>42707</c:v>
                </c:pt>
                <c:pt idx="116">
                  <c:v>42708</c:v>
                </c:pt>
                <c:pt idx="117">
                  <c:v>42709</c:v>
                </c:pt>
                <c:pt idx="118">
                  <c:v>42710</c:v>
                </c:pt>
                <c:pt idx="119">
                  <c:v>42711</c:v>
                </c:pt>
                <c:pt idx="120">
                  <c:v>42712</c:v>
                </c:pt>
                <c:pt idx="121">
                  <c:v>42713</c:v>
                </c:pt>
                <c:pt idx="122">
                  <c:v>42714</c:v>
                </c:pt>
                <c:pt idx="123">
                  <c:v>42715</c:v>
                </c:pt>
                <c:pt idx="124">
                  <c:v>42716</c:v>
                </c:pt>
                <c:pt idx="125">
                  <c:v>42717</c:v>
                </c:pt>
                <c:pt idx="126">
                  <c:v>42718</c:v>
                </c:pt>
                <c:pt idx="127">
                  <c:v>42719</c:v>
                </c:pt>
                <c:pt idx="128">
                  <c:v>42720</c:v>
                </c:pt>
                <c:pt idx="129">
                  <c:v>42721</c:v>
                </c:pt>
                <c:pt idx="130">
                  <c:v>42722</c:v>
                </c:pt>
                <c:pt idx="131">
                  <c:v>42723</c:v>
                </c:pt>
                <c:pt idx="132">
                  <c:v>42724</c:v>
                </c:pt>
              </c:numCache>
            </c:numRef>
          </c:cat>
          <c:val>
            <c:numRef>
              <c:f>Sheet3!$H$2:$H$134</c:f>
              <c:numCache>
                <c:formatCode>0.00</c:formatCode>
                <c:ptCount val="133"/>
                <c:pt idx="0">
                  <c:v>27.9</c:v>
                </c:pt>
                <c:pt idx="1">
                  <c:v>27.8</c:v>
                </c:pt>
                <c:pt idx="2">
                  <c:v>23.3</c:v>
                </c:pt>
                <c:pt idx="3">
                  <c:v>25.1</c:v>
                </c:pt>
                <c:pt idx="4">
                  <c:v>27.9</c:v>
                </c:pt>
                <c:pt idx="5">
                  <c:v>27.8</c:v>
                </c:pt>
                <c:pt idx="6">
                  <c:v>23.3</c:v>
                </c:pt>
                <c:pt idx="7">
                  <c:v>25.1</c:v>
                </c:pt>
                <c:pt idx="8">
                  <c:v>27.9</c:v>
                </c:pt>
                <c:pt idx="9">
                  <c:v>27.8</c:v>
                </c:pt>
                <c:pt idx="10">
                  <c:v>23.3</c:v>
                </c:pt>
                <c:pt idx="11">
                  <c:v>25.1</c:v>
                </c:pt>
                <c:pt idx="12">
                  <c:v>27.9</c:v>
                </c:pt>
                <c:pt idx="13">
                  <c:v>27.8</c:v>
                </c:pt>
                <c:pt idx="14">
                  <c:v>23.3</c:v>
                </c:pt>
                <c:pt idx="15">
                  <c:v>25.1</c:v>
                </c:pt>
                <c:pt idx="16">
                  <c:v>27.9</c:v>
                </c:pt>
                <c:pt idx="17">
                  <c:v>27.8</c:v>
                </c:pt>
                <c:pt idx="18">
                  <c:v>23.3</c:v>
                </c:pt>
                <c:pt idx="19">
                  <c:v>25.1</c:v>
                </c:pt>
                <c:pt idx="20">
                  <c:v>27.9</c:v>
                </c:pt>
                <c:pt idx="21">
                  <c:v>27.8</c:v>
                </c:pt>
                <c:pt idx="22">
                  <c:v>23.3</c:v>
                </c:pt>
                <c:pt idx="23">
                  <c:v>25.1</c:v>
                </c:pt>
                <c:pt idx="24">
                  <c:v>27.9</c:v>
                </c:pt>
                <c:pt idx="25">
                  <c:v>27.8</c:v>
                </c:pt>
                <c:pt idx="26">
                  <c:v>23.3</c:v>
                </c:pt>
                <c:pt idx="27">
                  <c:v>25.1</c:v>
                </c:pt>
                <c:pt idx="28">
                  <c:v>27.9</c:v>
                </c:pt>
                <c:pt idx="29">
                  <c:v>27.8</c:v>
                </c:pt>
                <c:pt idx="30">
                  <c:v>23.3</c:v>
                </c:pt>
                <c:pt idx="31">
                  <c:v>25.1</c:v>
                </c:pt>
                <c:pt idx="32">
                  <c:v>27.9</c:v>
                </c:pt>
                <c:pt idx="33">
                  <c:v>27.8</c:v>
                </c:pt>
                <c:pt idx="34">
                  <c:v>23.3</c:v>
                </c:pt>
                <c:pt idx="35">
                  <c:v>25.1</c:v>
                </c:pt>
                <c:pt idx="36">
                  <c:v>25.1</c:v>
                </c:pt>
                <c:pt idx="37">
                  <c:v>27.9</c:v>
                </c:pt>
                <c:pt idx="38">
                  <c:v>27.8</c:v>
                </c:pt>
                <c:pt idx="39">
                  <c:v>23.3</c:v>
                </c:pt>
                <c:pt idx="40">
                  <c:v>25.1</c:v>
                </c:pt>
                <c:pt idx="41">
                  <c:v>33.1</c:v>
                </c:pt>
                <c:pt idx="42">
                  <c:v>29</c:v>
                </c:pt>
                <c:pt idx="43">
                  <c:v>31.9</c:v>
                </c:pt>
                <c:pt idx="44">
                  <c:v>26.9</c:v>
                </c:pt>
                <c:pt idx="45">
                  <c:v>29.7</c:v>
                </c:pt>
                <c:pt idx="46">
                  <c:v>28.7</c:v>
                </c:pt>
                <c:pt idx="47">
                  <c:v>25.4</c:v>
                </c:pt>
                <c:pt idx="48">
                  <c:v>22.6</c:v>
                </c:pt>
                <c:pt idx="49">
                  <c:v>27.9</c:v>
                </c:pt>
                <c:pt idx="50">
                  <c:v>27.8</c:v>
                </c:pt>
                <c:pt idx="51">
                  <c:v>22.5</c:v>
                </c:pt>
                <c:pt idx="52">
                  <c:v>25.1</c:v>
                </c:pt>
                <c:pt idx="53">
                  <c:v>26.2</c:v>
                </c:pt>
                <c:pt idx="54">
                  <c:v>32.5</c:v>
                </c:pt>
                <c:pt idx="55">
                  <c:v>37.6</c:v>
                </c:pt>
                <c:pt idx="56">
                  <c:v>37.700000000000003</c:v>
                </c:pt>
                <c:pt idx="57">
                  <c:v>20.3</c:v>
                </c:pt>
                <c:pt idx="58">
                  <c:v>25.4</c:v>
                </c:pt>
                <c:pt idx="59">
                  <c:v>26.2</c:v>
                </c:pt>
                <c:pt idx="60">
                  <c:v>31.5</c:v>
                </c:pt>
                <c:pt idx="61">
                  <c:v>40.5</c:v>
                </c:pt>
                <c:pt idx="62">
                  <c:v>26.3</c:v>
                </c:pt>
                <c:pt idx="63">
                  <c:v>28.8</c:v>
                </c:pt>
                <c:pt idx="64">
                  <c:v>26</c:v>
                </c:pt>
                <c:pt idx="65">
                  <c:v>32.299999999999997</c:v>
                </c:pt>
                <c:pt idx="66">
                  <c:v>37.200000000000003</c:v>
                </c:pt>
                <c:pt idx="67">
                  <c:v>39.9</c:v>
                </c:pt>
                <c:pt idx="68">
                  <c:v>40.5</c:v>
                </c:pt>
                <c:pt idx="69">
                  <c:v>32.299999999999997</c:v>
                </c:pt>
                <c:pt idx="70">
                  <c:v>39.700000000000003</c:v>
                </c:pt>
                <c:pt idx="71">
                  <c:v>33.799999999999997</c:v>
                </c:pt>
                <c:pt idx="72">
                  <c:v>40.5</c:v>
                </c:pt>
                <c:pt idx="73">
                  <c:v>32.799999999999997</c:v>
                </c:pt>
                <c:pt idx="74">
                  <c:v>30.7</c:v>
                </c:pt>
                <c:pt idx="75">
                  <c:v>33.200000000000003</c:v>
                </c:pt>
                <c:pt idx="76">
                  <c:v>36.299999999999997</c:v>
                </c:pt>
                <c:pt idx="77">
                  <c:v>39.700000000000003</c:v>
                </c:pt>
                <c:pt idx="78">
                  <c:v>34.5</c:v>
                </c:pt>
                <c:pt idx="79">
                  <c:v>36</c:v>
                </c:pt>
                <c:pt idx="80">
                  <c:v>36.6</c:v>
                </c:pt>
                <c:pt idx="81">
                  <c:v>42.4</c:v>
                </c:pt>
                <c:pt idx="82">
                  <c:v>30.4</c:v>
                </c:pt>
                <c:pt idx="83">
                  <c:v>31.2</c:v>
                </c:pt>
                <c:pt idx="84">
                  <c:v>33.700000000000003</c:v>
                </c:pt>
                <c:pt idx="85">
                  <c:v>42.4</c:v>
                </c:pt>
                <c:pt idx="86">
                  <c:v>30.4</c:v>
                </c:pt>
                <c:pt idx="87">
                  <c:v>31.2</c:v>
                </c:pt>
                <c:pt idx="88">
                  <c:v>37.5</c:v>
                </c:pt>
                <c:pt idx="89">
                  <c:v>39.1</c:v>
                </c:pt>
                <c:pt idx="90">
                  <c:v>37.5</c:v>
                </c:pt>
                <c:pt idx="91">
                  <c:v>37.5</c:v>
                </c:pt>
                <c:pt idx="92">
                  <c:v>37.200000000000003</c:v>
                </c:pt>
                <c:pt idx="93">
                  <c:v>39.9</c:v>
                </c:pt>
                <c:pt idx="94">
                  <c:v>44.3</c:v>
                </c:pt>
                <c:pt idx="95">
                  <c:v>37.200000000000003</c:v>
                </c:pt>
                <c:pt idx="96">
                  <c:v>30.6</c:v>
                </c:pt>
                <c:pt idx="97">
                  <c:v>30.8</c:v>
                </c:pt>
                <c:pt idx="98">
                  <c:v>35.6</c:v>
                </c:pt>
                <c:pt idx="99">
                  <c:v>43.5</c:v>
                </c:pt>
                <c:pt idx="100">
                  <c:v>49.7</c:v>
                </c:pt>
                <c:pt idx="101">
                  <c:v>55.7</c:v>
                </c:pt>
                <c:pt idx="102">
                  <c:v>58.5</c:v>
                </c:pt>
                <c:pt idx="103">
                  <c:v>56</c:v>
                </c:pt>
                <c:pt idx="104">
                  <c:v>49.8</c:v>
                </c:pt>
                <c:pt idx="105">
                  <c:v>43.5</c:v>
                </c:pt>
                <c:pt idx="106">
                  <c:v>49.7</c:v>
                </c:pt>
                <c:pt idx="107">
                  <c:v>55.7</c:v>
                </c:pt>
                <c:pt idx="108">
                  <c:v>58.5</c:v>
                </c:pt>
                <c:pt idx="109">
                  <c:v>57.3</c:v>
                </c:pt>
                <c:pt idx="110">
                  <c:v>57.9</c:v>
                </c:pt>
                <c:pt idx="111">
                  <c:v>58.5</c:v>
                </c:pt>
                <c:pt idx="112">
                  <c:v>47.1</c:v>
                </c:pt>
                <c:pt idx="113">
                  <c:v>56.3</c:v>
                </c:pt>
                <c:pt idx="114">
                  <c:v>56.3</c:v>
                </c:pt>
                <c:pt idx="115">
                  <c:v>47.1</c:v>
                </c:pt>
                <c:pt idx="116">
                  <c:v>56.3</c:v>
                </c:pt>
                <c:pt idx="117">
                  <c:v>56.3</c:v>
                </c:pt>
                <c:pt idx="118">
                  <c:v>56.3</c:v>
                </c:pt>
                <c:pt idx="119">
                  <c:v>45.7</c:v>
                </c:pt>
                <c:pt idx="120">
                  <c:v>44</c:v>
                </c:pt>
                <c:pt idx="121">
                  <c:v>47.5</c:v>
                </c:pt>
                <c:pt idx="122">
                  <c:v>53.7</c:v>
                </c:pt>
                <c:pt idx="123">
                  <c:v>42.4</c:v>
                </c:pt>
                <c:pt idx="124">
                  <c:v>50.7</c:v>
                </c:pt>
                <c:pt idx="125">
                  <c:v>50.6</c:v>
                </c:pt>
                <c:pt idx="126">
                  <c:v>56.6</c:v>
                </c:pt>
                <c:pt idx="127">
                  <c:v>59.3</c:v>
                </c:pt>
                <c:pt idx="128">
                  <c:v>50.7</c:v>
                </c:pt>
                <c:pt idx="129">
                  <c:v>56.6</c:v>
                </c:pt>
                <c:pt idx="130">
                  <c:v>59.3</c:v>
                </c:pt>
                <c:pt idx="131">
                  <c:v>50.7</c:v>
                </c:pt>
                <c:pt idx="132">
                  <c:v>59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101-8745-B760-0A032D8E2A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680196320"/>
        <c:axId val="-735948688"/>
      </c:lineChart>
      <c:dateAx>
        <c:axId val="-675653200"/>
        <c:scaling>
          <c:orientation val="minMax"/>
        </c:scaling>
        <c:delete val="0"/>
        <c:axPos val="b"/>
        <c:numFmt formatCode="m/d/yy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75652656"/>
        <c:crosses val="autoZero"/>
        <c:auto val="0"/>
        <c:lblOffset val="100"/>
        <c:baseTimeUnit val="days"/>
        <c:majorUnit val="7"/>
        <c:majorTimeUnit val="days"/>
      </c:dateAx>
      <c:valAx>
        <c:axId val="-6756526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75653200"/>
        <c:crossesAt val="42592"/>
        <c:crossBetween val="between"/>
      </c:valAx>
      <c:valAx>
        <c:axId val="-735948688"/>
        <c:scaling>
          <c:orientation val="minMax"/>
        </c:scaling>
        <c:delete val="0"/>
        <c:axPos val="r"/>
        <c:numFmt formatCode="0.0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680196320"/>
        <c:crosses val="max"/>
        <c:crossBetween val="between"/>
        <c:majorUnit val="5"/>
      </c:valAx>
      <c:dateAx>
        <c:axId val="-1680196320"/>
        <c:scaling>
          <c:orientation val="minMax"/>
        </c:scaling>
        <c:delete val="1"/>
        <c:axPos val="b"/>
        <c:numFmt formatCode="m/d/yyyy" sourceLinked="1"/>
        <c:majorTickMark val="out"/>
        <c:minorTickMark val="none"/>
        <c:tickLblPos val="nextTo"/>
        <c:crossAx val="-735948688"/>
        <c:crosses val="autoZero"/>
        <c:auto val="1"/>
        <c:lblOffset val="100"/>
        <c:baseTimeUnit val="days"/>
      </c:date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3335</cdr:x>
      <cdr:y>0.83358</cdr:y>
    </cdr:from>
    <cdr:to>
      <cdr:x>0.54898</cdr:x>
      <cdr:y>0.88012</cdr:y>
    </cdr:to>
    <cdr:sp macro="" textlink="">
      <cdr:nvSpPr>
        <cdr:cNvPr id="5" name="TextBox 1"/>
        <cdr:cNvSpPr txBox="1"/>
      </cdr:nvSpPr>
      <cdr:spPr>
        <a:xfrm xmlns:a="http://schemas.openxmlformats.org/drawingml/2006/main" rot="19194080">
          <a:off x="2471780" y="3238932"/>
          <a:ext cx="659508" cy="18084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n-AU" sz="700" dirty="0">
              <a:latin typeface="Arial" panose="020B0604020202020204" pitchFamily="34" charset="0"/>
              <a:cs typeface="Arial" panose="020B0604020202020204" pitchFamily="34" charset="0"/>
            </a:rPr>
            <a:t>Heading</a:t>
          </a:r>
        </a:p>
      </cdr:txBody>
    </cdr:sp>
  </cdr:relSizeAnchor>
  <cdr:relSizeAnchor xmlns:cdr="http://schemas.openxmlformats.org/drawingml/2006/chartDrawing">
    <cdr:from>
      <cdr:x>0.46601</cdr:x>
      <cdr:y>0.83491</cdr:y>
    </cdr:from>
    <cdr:to>
      <cdr:x>0.57828</cdr:x>
      <cdr:y>0.88255</cdr:y>
    </cdr:to>
    <cdr:sp macro="" textlink="">
      <cdr:nvSpPr>
        <cdr:cNvPr id="6" name="TextBox 1"/>
        <cdr:cNvSpPr txBox="1"/>
      </cdr:nvSpPr>
      <cdr:spPr>
        <a:xfrm xmlns:a="http://schemas.openxmlformats.org/drawingml/2006/main" rot="19364433">
          <a:off x="2658047" y="3244102"/>
          <a:ext cx="640388" cy="1851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n-AU" sz="700" dirty="0" err="1">
              <a:latin typeface="Arial" panose="020B0604020202020204" pitchFamily="34" charset="0"/>
              <a:cs typeface="Arial" panose="020B0604020202020204" pitchFamily="34" charset="0"/>
            </a:rPr>
            <a:t>Anthesis</a:t>
          </a:r>
          <a:endParaRPr lang="en-AU" sz="7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34434</cdr:x>
      <cdr:y>0.84904</cdr:y>
    </cdr:from>
    <cdr:to>
      <cdr:x>0.50351</cdr:x>
      <cdr:y>0.90053</cdr:y>
    </cdr:to>
    <cdr:sp macro="" textlink="">
      <cdr:nvSpPr>
        <cdr:cNvPr id="7" name="TextBox 33"/>
        <cdr:cNvSpPr txBox="1"/>
      </cdr:nvSpPr>
      <cdr:spPr>
        <a:xfrm xmlns:a="http://schemas.openxmlformats.org/drawingml/2006/main" rot="19506268">
          <a:off x="1964033" y="3299025"/>
          <a:ext cx="907875" cy="200055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n-AU" sz="700" b="0" dirty="0">
              <a:latin typeface="Arial" panose="020B0604020202020204" pitchFamily="34" charset="0"/>
              <a:cs typeface="Arial" panose="020B0604020202020204" pitchFamily="34" charset="0"/>
            </a:rPr>
            <a:t>Early booting</a:t>
          </a:r>
        </a:p>
      </cdr:txBody>
    </cdr:sp>
  </cdr:relSizeAnchor>
  <cdr:relSizeAnchor xmlns:cdr="http://schemas.openxmlformats.org/drawingml/2006/chartDrawing">
    <cdr:from>
      <cdr:x>0.53673</cdr:x>
      <cdr:y>0.77789</cdr:y>
    </cdr:from>
    <cdr:to>
      <cdr:x>0.5718</cdr:x>
      <cdr:y>0.95235</cdr:y>
    </cdr:to>
    <cdr:sp macro="" textlink="">
      <cdr:nvSpPr>
        <cdr:cNvPr id="8" name="TextBox 35"/>
        <cdr:cNvSpPr txBox="1"/>
      </cdr:nvSpPr>
      <cdr:spPr>
        <a:xfrm xmlns:a="http://schemas.openxmlformats.org/drawingml/2006/main" rot="18882367">
          <a:off x="2822502" y="3261472"/>
          <a:ext cx="677874" cy="200055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n-AU" sz="700" dirty="0">
              <a:latin typeface="Arial" panose="020B0604020202020204" pitchFamily="34" charset="0"/>
              <a:cs typeface="Arial" panose="020B0604020202020204" pitchFamily="34" charset="0"/>
            </a:rPr>
            <a:t>Maturity</a:t>
          </a:r>
        </a:p>
      </cdr:txBody>
    </cdr:sp>
  </cdr:relSizeAnchor>
  <cdr:relSizeAnchor xmlns:cdr="http://schemas.openxmlformats.org/drawingml/2006/chartDrawing">
    <cdr:from>
      <cdr:x>0.51153</cdr:x>
      <cdr:y>0.78944</cdr:y>
    </cdr:from>
    <cdr:to>
      <cdr:x>0.58393</cdr:x>
      <cdr:y>0.80797</cdr:y>
    </cdr:to>
    <cdr:sp macro="" textlink="">
      <cdr:nvSpPr>
        <cdr:cNvPr id="10" name="Rectangle 9"/>
        <cdr:cNvSpPr/>
      </cdr:nvSpPr>
      <cdr:spPr>
        <a:xfrm xmlns:a="http://schemas.openxmlformats.org/drawingml/2006/main">
          <a:off x="2917705" y="3067442"/>
          <a:ext cx="412952" cy="72000"/>
        </a:xfrm>
        <a:prstGeom xmlns:a="http://schemas.openxmlformats.org/drawingml/2006/main" prst="rect">
          <a:avLst/>
        </a:prstGeom>
        <a:solidFill xmlns:a="http://schemas.openxmlformats.org/drawingml/2006/main">
          <a:schemeClr val="bg2">
            <a:lumMod val="75000"/>
          </a:schemeClr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AU" sz="110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4374</cdr:x>
      <cdr:y>0.78944</cdr:y>
    </cdr:from>
    <cdr:to>
      <cdr:x>0.61167</cdr:x>
      <cdr:y>0.80797</cdr:y>
    </cdr:to>
    <cdr:sp macro="" textlink="">
      <cdr:nvSpPr>
        <cdr:cNvPr id="11" name="Rectangle 10"/>
        <cdr:cNvSpPr/>
      </cdr:nvSpPr>
      <cdr:spPr>
        <a:xfrm xmlns:a="http://schemas.openxmlformats.org/drawingml/2006/main">
          <a:off x="3101405" y="3067454"/>
          <a:ext cx="387478" cy="72000"/>
        </a:xfrm>
        <a:prstGeom xmlns:a="http://schemas.openxmlformats.org/drawingml/2006/main" prst="rect">
          <a:avLst/>
        </a:prstGeom>
        <a:solidFill xmlns:a="http://schemas.openxmlformats.org/drawingml/2006/main">
          <a:schemeClr val="tx1">
            <a:lumMod val="65000"/>
            <a:lumOff val="35000"/>
          </a:schemeClr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AU" sz="110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4227</cdr:x>
      <cdr:y>0.78945</cdr:y>
    </cdr:from>
    <cdr:to>
      <cdr:x>0.49389</cdr:x>
      <cdr:y>0.80798</cdr:y>
    </cdr:to>
    <cdr:sp macro="" textlink="">
      <cdr:nvSpPr>
        <cdr:cNvPr id="12" name="Rectangle 11"/>
        <cdr:cNvSpPr/>
      </cdr:nvSpPr>
      <cdr:spPr>
        <a:xfrm xmlns:a="http://schemas.openxmlformats.org/drawingml/2006/main">
          <a:off x="2522626" y="3067474"/>
          <a:ext cx="294414" cy="72000"/>
        </a:xfrm>
        <a:prstGeom xmlns:a="http://schemas.openxmlformats.org/drawingml/2006/main" prst="rect">
          <a:avLst/>
        </a:prstGeom>
        <a:solidFill xmlns:a="http://schemas.openxmlformats.org/drawingml/2006/main">
          <a:schemeClr val="tx1">
            <a:lumMod val="65000"/>
            <a:lumOff val="35000"/>
          </a:schemeClr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sz="110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8474</cdr:x>
      <cdr:y>0.78918</cdr:y>
    </cdr:from>
    <cdr:to>
      <cdr:x>0.63492</cdr:x>
      <cdr:y>0.80771</cdr:y>
    </cdr:to>
    <cdr:sp macro="" textlink="">
      <cdr:nvSpPr>
        <cdr:cNvPr id="4" name="Rectangle 3"/>
        <cdr:cNvSpPr/>
      </cdr:nvSpPr>
      <cdr:spPr>
        <a:xfrm xmlns:a="http://schemas.openxmlformats.org/drawingml/2006/main">
          <a:off x="3335239" y="3066438"/>
          <a:ext cx="286238" cy="72000"/>
        </a:xfrm>
        <a:prstGeom xmlns:a="http://schemas.openxmlformats.org/drawingml/2006/main" prst="rect">
          <a:avLst/>
        </a:prstGeom>
        <a:solidFill xmlns:a="http://schemas.openxmlformats.org/drawingml/2006/main">
          <a:schemeClr val="tx1">
            <a:lumMod val="65000"/>
            <a:lumOff val="35000"/>
          </a:schemeClr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sz="110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37884</cdr:x>
      <cdr:y>0.79069</cdr:y>
    </cdr:from>
    <cdr:to>
      <cdr:x>0.3958</cdr:x>
      <cdr:y>0.80922</cdr:y>
    </cdr:to>
    <cdr:sp macro="" textlink="">
      <cdr:nvSpPr>
        <cdr:cNvPr id="13" name="TextBox 1"/>
        <cdr:cNvSpPr txBox="1"/>
      </cdr:nvSpPr>
      <cdr:spPr>
        <a:xfrm xmlns:a="http://schemas.openxmlformats.org/drawingml/2006/main">
          <a:off x="2160834" y="3072299"/>
          <a:ext cx="96760" cy="72000"/>
        </a:xfrm>
        <a:prstGeom xmlns:a="http://schemas.openxmlformats.org/drawingml/2006/main" prst="rect">
          <a:avLst/>
        </a:prstGeom>
        <a:solidFill xmlns:a="http://schemas.openxmlformats.org/drawingml/2006/main">
          <a:srgbClr val="00B0F0"/>
        </a:solidFill>
        <a:ln xmlns:a="http://schemas.openxmlformats.org/drawingml/2006/main">
          <a:noFill/>
        </a:ln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AU" sz="1100" dirty="0"/>
        </a:p>
      </cdr:txBody>
    </cdr:sp>
  </cdr:relSizeAnchor>
  <cdr:relSizeAnchor xmlns:cdr="http://schemas.openxmlformats.org/drawingml/2006/chartDrawing">
    <cdr:from>
      <cdr:x>0.25542</cdr:x>
      <cdr:y>0.84876</cdr:y>
    </cdr:from>
    <cdr:to>
      <cdr:x>0.42063</cdr:x>
      <cdr:y>0.92043</cdr:y>
    </cdr:to>
    <cdr:sp macro="" textlink="">
      <cdr:nvSpPr>
        <cdr:cNvPr id="14" name="TextBox 13"/>
        <cdr:cNvSpPr txBox="1"/>
      </cdr:nvSpPr>
      <cdr:spPr>
        <a:xfrm xmlns:a="http://schemas.openxmlformats.org/drawingml/2006/main" rot="19465441">
          <a:off x="1456847" y="3297917"/>
          <a:ext cx="942345" cy="27848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r"/>
          <a:r>
            <a:rPr lang="en-AU" sz="700" dirty="0">
              <a:latin typeface="Arial" panose="020B0604020202020204" pitchFamily="34" charset="0"/>
              <a:cs typeface="Arial" panose="020B0604020202020204" pitchFamily="34" charset="0"/>
            </a:rPr>
            <a:t>Last irrigation</a:t>
          </a:r>
        </a:p>
      </cdr:txBody>
    </cdr:sp>
  </cdr:relSizeAnchor>
  <cdr:relSizeAnchor xmlns:cdr="http://schemas.openxmlformats.org/drawingml/2006/chartDrawing">
    <cdr:from>
      <cdr:x>0.57081</cdr:x>
      <cdr:y>0.78945</cdr:y>
    </cdr:from>
    <cdr:to>
      <cdr:x>0.59995</cdr:x>
      <cdr:y>0.80798</cdr:y>
    </cdr:to>
    <cdr:sp macro="" textlink="">
      <cdr:nvSpPr>
        <cdr:cNvPr id="17" name="Rectangle 16"/>
        <cdr:cNvSpPr/>
      </cdr:nvSpPr>
      <cdr:spPr>
        <a:xfrm xmlns:a="http://schemas.openxmlformats.org/drawingml/2006/main">
          <a:off x="3255826" y="3067493"/>
          <a:ext cx="166206" cy="72000"/>
        </a:xfrm>
        <a:prstGeom xmlns:a="http://schemas.openxmlformats.org/drawingml/2006/main" prst="rect">
          <a:avLst/>
        </a:prstGeom>
        <a:solidFill xmlns:a="http://schemas.openxmlformats.org/drawingml/2006/main">
          <a:schemeClr val="bg2">
            <a:lumMod val="75000"/>
          </a:schemeClr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51601</cdr:x>
      <cdr:y>0.83946</cdr:y>
    </cdr:from>
    <cdr:to>
      <cdr:x>0.65153</cdr:x>
      <cdr:y>0.8871</cdr:y>
    </cdr:to>
    <cdr:sp macro="" textlink="">
      <cdr:nvSpPr>
        <cdr:cNvPr id="19" name="TextBox 1"/>
        <cdr:cNvSpPr txBox="1"/>
      </cdr:nvSpPr>
      <cdr:spPr>
        <a:xfrm xmlns:a="http://schemas.openxmlformats.org/drawingml/2006/main" rot="19125344">
          <a:off x="2943235" y="3261791"/>
          <a:ext cx="773006" cy="1851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n-AU" sz="700" dirty="0">
              <a:latin typeface="Arial" panose="020B0604020202020204" pitchFamily="34" charset="0"/>
              <a:cs typeface="Arial" panose="020B0604020202020204" pitchFamily="34" charset="0"/>
            </a:rPr>
            <a:t>Grain</a:t>
          </a:r>
          <a:r>
            <a:rPr lang="en-AU" sz="600" dirty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n-AU" sz="700" dirty="0">
              <a:latin typeface="Arial" panose="020B0604020202020204" pitchFamily="34" charset="0"/>
              <a:cs typeface="Arial" panose="020B0604020202020204" pitchFamily="34" charset="0"/>
            </a:rPr>
            <a:t>filling</a:t>
          </a:r>
          <a:endParaRPr lang="en-AU" sz="6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CE93-58EA-B246-A2A3-5E3FD868486A}" type="datetimeFigureOut">
              <a:rPr lang="en-US" smtClean="0"/>
              <a:t>7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3A9A84-9978-7540-B768-A84188921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448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CE93-58EA-B246-A2A3-5E3FD868486A}" type="datetimeFigureOut">
              <a:rPr lang="en-US" smtClean="0"/>
              <a:t>7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3A9A84-9978-7540-B768-A84188921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607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CE93-58EA-B246-A2A3-5E3FD868486A}" type="datetimeFigureOut">
              <a:rPr lang="en-US" smtClean="0"/>
              <a:t>7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3A9A84-9978-7540-B768-A84188921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668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CE93-58EA-B246-A2A3-5E3FD868486A}" type="datetimeFigureOut">
              <a:rPr lang="en-US" smtClean="0"/>
              <a:t>7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3A9A84-9978-7540-B768-A84188921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3143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CE93-58EA-B246-A2A3-5E3FD868486A}" type="datetimeFigureOut">
              <a:rPr lang="en-US" smtClean="0"/>
              <a:t>7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3A9A84-9978-7540-B768-A84188921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930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CE93-58EA-B246-A2A3-5E3FD868486A}" type="datetimeFigureOut">
              <a:rPr lang="en-US" smtClean="0"/>
              <a:t>7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3A9A84-9978-7540-B768-A84188921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578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CE93-58EA-B246-A2A3-5E3FD868486A}" type="datetimeFigureOut">
              <a:rPr lang="en-US" smtClean="0"/>
              <a:t>7/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3A9A84-9978-7540-B768-A84188921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6560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CE93-58EA-B246-A2A3-5E3FD868486A}" type="datetimeFigureOut">
              <a:rPr lang="en-US" smtClean="0"/>
              <a:t>7/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3A9A84-9978-7540-B768-A84188921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096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CE93-58EA-B246-A2A3-5E3FD868486A}" type="datetimeFigureOut">
              <a:rPr lang="en-US" smtClean="0"/>
              <a:t>7/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3A9A84-9978-7540-B768-A84188921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5052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CE93-58EA-B246-A2A3-5E3FD868486A}" type="datetimeFigureOut">
              <a:rPr lang="en-US" smtClean="0"/>
              <a:t>7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3A9A84-9978-7540-B768-A84188921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867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5CE93-58EA-B246-A2A3-5E3FD868486A}" type="datetimeFigureOut">
              <a:rPr lang="en-US" smtClean="0"/>
              <a:t>7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3A9A84-9978-7540-B768-A84188921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890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5CE93-58EA-B246-A2A3-5E3FD868486A}" type="datetimeFigureOut">
              <a:rPr lang="en-US" smtClean="0"/>
              <a:t>7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3A9A84-9978-7540-B768-A84188921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054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4825CCE8-4007-AC49-9E47-6DB7EBD51FC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3763385"/>
              </p:ext>
            </p:extLst>
          </p:nvPr>
        </p:nvGraphicFramePr>
        <p:xfrm>
          <a:off x="925441" y="998383"/>
          <a:ext cx="5703830" cy="38855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93558FA0-B326-484A-AC57-2326EF6C1532}"/>
              </a:ext>
            </a:extLst>
          </p:cNvPr>
          <p:cNvSpPr txBox="1"/>
          <p:nvPr/>
        </p:nvSpPr>
        <p:spPr>
          <a:xfrm>
            <a:off x="6083061" y="1295401"/>
            <a:ext cx="346249" cy="192770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05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ily max. temperature (</a:t>
            </a:r>
            <a:r>
              <a:rPr lang="en-AU" sz="1050" baseline="30000" dirty="0" err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AU" sz="1050" dirty="0" err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AU" sz="105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579C730-8FFD-C84D-8D2B-1C5DBBD1E1AD}"/>
              </a:ext>
            </a:extLst>
          </p:cNvPr>
          <p:cNvSpPr txBox="1"/>
          <p:nvPr/>
        </p:nvSpPr>
        <p:spPr>
          <a:xfrm>
            <a:off x="438850" y="1061062"/>
            <a:ext cx="346249" cy="196729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AU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il water potential (kPa)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B3FF3775-C174-5543-B9B3-2D47856A8290}"/>
              </a:ext>
            </a:extLst>
          </p:cNvPr>
          <p:cNvGrpSpPr/>
          <p:nvPr/>
        </p:nvGrpSpPr>
        <p:grpSpPr>
          <a:xfrm>
            <a:off x="785099" y="4855289"/>
            <a:ext cx="2723256" cy="443071"/>
            <a:chOff x="1054100" y="5242639"/>
            <a:chExt cx="2723256" cy="443071"/>
          </a:xfrm>
        </p:grpSpPr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30D89F2B-C01B-9544-9565-1B0B105ED279}"/>
                </a:ext>
              </a:extLst>
            </p:cNvPr>
            <p:cNvCxnSpPr/>
            <p:nvPr/>
          </p:nvCxnSpPr>
          <p:spPr>
            <a:xfrm>
              <a:off x="1054100" y="5365750"/>
              <a:ext cx="22225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55278C9-7215-E545-A308-5009404D151C}"/>
                </a:ext>
              </a:extLst>
            </p:cNvPr>
            <p:cNvSpPr txBox="1"/>
            <p:nvPr/>
          </p:nvSpPr>
          <p:spPr>
            <a:xfrm>
              <a:off x="1276350" y="5242639"/>
              <a:ext cx="25010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oil water potential (kPa) at 10 cm depth</a:t>
              </a: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0F70473D-8CE0-0F46-B3AB-42CB21055C9D}"/>
                </a:ext>
              </a:extLst>
            </p:cNvPr>
            <p:cNvCxnSpPr/>
            <p:nvPr/>
          </p:nvCxnSpPr>
          <p:spPr>
            <a:xfrm>
              <a:off x="1054100" y="5562600"/>
              <a:ext cx="222250" cy="0"/>
            </a:xfrm>
            <a:prstGeom prst="line">
              <a:avLst/>
            </a:prstGeom>
            <a:ln w="381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B647C96-10EE-994F-AEA8-D11F2C028CFD}"/>
                </a:ext>
              </a:extLst>
            </p:cNvPr>
            <p:cNvSpPr txBox="1"/>
            <p:nvPr/>
          </p:nvSpPr>
          <p:spPr>
            <a:xfrm>
              <a:off x="1276350" y="5439489"/>
              <a:ext cx="25010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oil water potential (kPa) at 40 cm depth</a:t>
              </a:r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93969620-4E4B-B943-A3E5-A3290E9D9701}"/>
              </a:ext>
            </a:extLst>
          </p:cNvPr>
          <p:cNvSpPr/>
          <p:nvPr/>
        </p:nvSpPr>
        <p:spPr>
          <a:xfrm>
            <a:off x="611974" y="5937752"/>
            <a:ext cx="5673323" cy="49898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en-AU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. S1</a:t>
            </a:r>
            <a:r>
              <a:rPr lang="en-AU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il water potential and maximum air temperature during 2016 field trial (Urrbrae, South Australia) on Excalibur/Kukri NIL.</a:t>
            </a:r>
          </a:p>
        </p:txBody>
      </p:sp>
    </p:spTree>
    <p:extLst>
      <p:ext uri="{BB962C8B-B14F-4D97-AF65-F5344CB8AC3E}">
        <p14:creationId xmlns:p14="http://schemas.microsoft.com/office/powerpoint/2010/main" val="37767419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A close up of a logo&#10;&#10;Description automatically generated">
            <a:extLst>
              <a:ext uri="{FF2B5EF4-FFF2-40B4-BE49-F238E27FC236}">
                <a16:creationId xmlns:a16="http://schemas.microsoft.com/office/drawing/2014/main" id="{6E143A0F-A4BC-6643-B73A-43B2CD3BA7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9625" y="885730"/>
            <a:ext cx="2766060" cy="222182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09B8FBA-638A-B04B-A839-9069F20235A8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45685" y="745289"/>
            <a:ext cx="2766060" cy="2225040"/>
          </a:xfrm>
          <a:prstGeom prst="rect">
            <a:avLst/>
          </a:prstGeom>
          <a:noFill/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DC18D12-A737-8447-BF47-5DD4C55DCA74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327" y="3115493"/>
            <a:ext cx="2834005" cy="2277745"/>
          </a:xfrm>
          <a:prstGeom prst="rect">
            <a:avLst/>
          </a:prstGeom>
          <a:noFill/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F1BA4F7-D20E-7F42-BBCA-11791389B49F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9330" y="3131368"/>
            <a:ext cx="2812415" cy="2261870"/>
          </a:xfrm>
          <a:prstGeom prst="rect">
            <a:avLst/>
          </a:prstGeom>
          <a:noFill/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15647CB-08E1-904C-BC9D-EA3725B00FBF}"/>
              </a:ext>
            </a:extLst>
          </p:cNvPr>
          <p:cNvSpPr txBox="1"/>
          <p:nvPr/>
        </p:nvSpPr>
        <p:spPr>
          <a:xfrm>
            <a:off x="802694" y="92876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2B4ED0C-3BF4-A34B-89C0-8566017DB3E3}"/>
              </a:ext>
            </a:extLst>
          </p:cNvPr>
          <p:cNvSpPr txBox="1"/>
          <p:nvPr/>
        </p:nvSpPr>
        <p:spPr>
          <a:xfrm>
            <a:off x="810710" y="341752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09A84F1-BF7C-B14A-83AA-31E35993C4B0}"/>
              </a:ext>
            </a:extLst>
          </p:cNvPr>
          <p:cNvSpPr txBox="1"/>
          <p:nvPr/>
        </p:nvSpPr>
        <p:spPr>
          <a:xfrm>
            <a:off x="3615109" y="92876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E20F0E4-23A0-AF4C-AD72-E311F4E6EB63}"/>
              </a:ext>
            </a:extLst>
          </p:cNvPr>
          <p:cNvSpPr txBox="1"/>
          <p:nvPr/>
        </p:nvSpPr>
        <p:spPr>
          <a:xfrm>
            <a:off x="3615109" y="3418759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E23DCD01-F2D4-2748-AF89-C331BF054B0F}"/>
              </a:ext>
            </a:extLst>
          </p:cNvPr>
          <p:cNvSpPr/>
          <p:nvPr/>
        </p:nvSpPr>
        <p:spPr>
          <a:xfrm>
            <a:off x="616016" y="5794409"/>
            <a:ext cx="5395729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. S2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Genetic correlations among the field trials of Excalibur/Kukri DH population for grain yield (a), TGW (b), days to heading (c) and grain filling period (d) derived from MET model. </a:t>
            </a:r>
            <a:r>
              <a:rPr lang="en-US" sz="1200" dirty="0">
                <a:latin typeface="Times New Roman" panose="02020603050405020304" pitchFamily="18" charset="0"/>
              </a:rPr>
              <a:t>Each square represents a pairwise correlation coefficient between sites and the color of the squares indicate the value of the coefficient. </a:t>
            </a:r>
            <a:r>
              <a:rPr lang="en-US" sz="1200" dirty="0" err="1">
                <a:latin typeface="Times New Roman" panose="02020603050405020304" pitchFamily="18" charset="0"/>
              </a:rPr>
              <a:t>Aus</a:t>
            </a:r>
            <a:r>
              <a:rPr lang="en-US" sz="1200" dirty="0">
                <a:latin typeface="Times New Roman" panose="02020603050405020304" pitchFamily="18" charset="0"/>
              </a:rPr>
              <a:t> = Australia, Mex = Mexico, Ind = India,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oo =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ooleroo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2006 &amp; 2007,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Obr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= Obregon 2007, Min =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innipa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2006 &amp; 2007, Ros =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oseworthy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2006 &amp; 2007, His =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isan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2011 &amp; 2012, Kan =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Kanpura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2010, 2011 &amp; 2012, Pun = Pune 2010, 2011 &amp; 2012, rf = rainfed,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r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= irrigated trial.</a:t>
            </a:r>
            <a:endParaRPr lang="en-AU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97572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90E6156-E5A0-064D-99FF-69DE5A79B636}"/>
              </a:ext>
            </a:extLst>
          </p:cNvPr>
          <p:cNvGrpSpPr/>
          <p:nvPr/>
        </p:nvGrpSpPr>
        <p:grpSpPr>
          <a:xfrm>
            <a:off x="433980" y="944172"/>
            <a:ext cx="5865908" cy="2815931"/>
            <a:chOff x="914271" y="223736"/>
            <a:chExt cx="5865908" cy="2815931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91E42086-179B-9741-B832-BBDBE58BE732}"/>
                </a:ext>
              </a:extLst>
            </p:cNvPr>
            <p:cNvGrpSpPr/>
            <p:nvPr/>
          </p:nvGrpSpPr>
          <p:grpSpPr>
            <a:xfrm>
              <a:off x="914271" y="223736"/>
              <a:ext cx="5865908" cy="2604952"/>
              <a:chOff x="914271" y="223736"/>
              <a:chExt cx="5865908" cy="2604952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FDAB21D8-BEB4-6342-871C-CABC0244F1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9136" b="14046"/>
              <a:stretch/>
            </p:blipFill>
            <p:spPr>
              <a:xfrm>
                <a:off x="914271" y="223736"/>
                <a:ext cx="5865908" cy="2097121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518392EE-EB87-AE45-BC99-1711401294B0}"/>
                  </a:ext>
                </a:extLst>
              </p:cNvPr>
              <p:cNvSpPr txBox="1"/>
              <p:nvPr/>
            </p:nvSpPr>
            <p:spPr>
              <a:xfrm>
                <a:off x="1371472" y="2320857"/>
                <a:ext cx="2753056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87313" indent="-87313">
                  <a:buFont typeface="Arial" panose="020B0604020202020204" pitchFamily="34" charset="0"/>
                  <a:buChar char="•"/>
                </a:pPr>
                <a:r>
                  <a:rPr lang="en-AU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arkers in green are flanking yield QTL peaks.</a:t>
                </a:r>
              </a:p>
              <a:p>
                <a:pPr marL="87313" indent="-87313">
                  <a:buFont typeface="Arial" panose="020B0604020202020204" pitchFamily="34" charset="0"/>
                  <a:buChar char="•"/>
                </a:pPr>
                <a:r>
                  <a:rPr lang="en-AU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arkers in grey were used for NILs development and analysis.</a:t>
                </a:r>
              </a:p>
            </p:txBody>
          </p:sp>
        </p:grp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9DD66E9E-4235-AC41-A748-E062CE1323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5532" b="3079"/>
            <a:stretch/>
          </p:blipFill>
          <p:spPr>
            <a:xfrm>
              <a:off x="4551230" y="2320857"/>
              <a:ext cx="1245039" cy="718810"/>
            </a:xfrm>
            <a:prstGeom prst="rect">
              <a:avLst/>
            </a:prstGeom>
          </p:spPr>
        </p:pic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AE3202FF-8C84-9847-9829-A27828543C71}"/>
              </a:ext>
            </a:extLst>
          </p:cNvPr>
          <p:cNvGrpSpPr/>
          <p:nvPr/>
        </p:nvGrpSpPr>
        <p:grpSpPr>
          <a:xfrm>
            <a:off x="433980" y="3879683"/>
            <a:ext cx="5982640" cy="3100877"/>
            <a:chOff x="914271" y="3159247"/>
            <a:chExt cx="5982640" cy="3100877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3399B96E-A77A-874F-BB6D-4753E31EC2A4}"/>
                </a:ext>
              </a:extLst>
            </p:cNvPr>
            <p:cNvGrpSpPr/>
            <p:nvPr/>
          </p:nvGrpSpPr>
          <p:grpSpPr>
            <a:xfrm>
              <a:off x="914271" y="3159247"/>
              <a:ext cx="5982640" cy="2864157"/>
              <a:chOff x="914271" y="3159247"/>
              <a:chExt cx="5982640" cy="2864157"/>
            </a:xfrm>
          </p:grpSpPr>
          <p:pic>
            <p:nvPicPr>
              <p:cNvPr id="10" name="Content Placeholder 3">
                <a:extLst>
                  <a:ext uri="{FF2B5EF4-FFF2-40B4-BE49-F238E27FC236}">
                    <a16:creationId xmlns:a16="http://schemas.microsoft.com/office/drawing/2014/main" id="{0A41B23D-1D48-404C-8139-B20861E6E60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8732" b="14219"/>
              <a:stretch/>
            </p:blipFill>
            <p:spPr>
              <a:xfrm>
                <a:off x="914271" y="3159247"/>
                <a:ext cx="5982640" cy="2356326"/>
              </a:xfrm>
              <a:prstGeom prst="rect">
                <a:avLst/>
              </a:prstGeom>
            </p:spPr>
          </p:pic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72F63C33-103E-5940-B2FF-15639E14187F}"/>
                  </a:ext>
                </a:extLst>
              </p:cNvPr>
              <p:cNvSpPr txBox="1"/>
              <p:nvPr/>
            </p:nvSpPr>
            <p:spPr>
              <a:xfrm>
                <a:off x="1270952" y="5515573"/>
                <a:ext cx="2775753" cy="5078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87313" indent="-87313">
                  <a:buFont typeface="Arial" panose="020B0604020202020204" pitchFamily="34" charset="0"/>
                  <a:buChar char="•"/>
                </a:pPr>
                <a:r>
                  <a:rPr lang="en-AU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arkers in green are flanking TGW QTL peak.</a:t>
                </a:r>
              </a:p>
              <a:p>
                <a:pPr marL="87313" indent="-87313">
                  <a:buFont typeface="Arial" panose="020B0604020202020204" pitchFamily="34" charset="0"/>
                  <a:buChar char="•"/>
                </a:pPr>
                <a:r>
                  <a:rPr lang="en-AU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arkers in grey were used for NILs development and analysis.</a:t>
                </a:r>
              </a:p>
            </p:txBody>
          </p:sp>
        </p:grp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208E5FD-6EC1-DC49-B148-2F4AFA9677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24881" b="3515"/>
            <a:stretch/>
          </p:blipFill>
          <p:spPr>
            <a:xfrm>
              <a:off x="4619139" y="5515574"/>
              <a:ext cx="1277568" cy="744550"/>
            </a:xfrm>
            <a:prstGeom prst="rect">
              <a:avLst/>
            </a:prstGeom>
          </p:spPr>
        </p:pic>
      </p:grpSp>
      <p:sp>
        <p:nvSpPr>
          <p:cNvPr id="12" name="Rectangle 11">
            <a:extLst>
              <a:ext uri="{FF2B5EF4-FFF2-40B4-BE49-F238E27FC236}">
                <a16:creationId xmlns:a16="http://schemas.microsoft.com/office/drawing/2014/main" id="{2CE9049A-B341-874A-BF27-66038FFBF845}"/>
              </a:ext>
            </a:extLst>
          </p:cNvPr>
          <p:cNvSpPr/>
          <p:nvPr/>
        </p:nvSpPr>
        <p:spPr>
          <a:xfrm>
            <a:off x="619736" y="7444939"/>
            <a:ext cx="589335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. S3 </a:t>
            </a:r>
            <a:r>
              <a:rPr lang="en-AU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TL for yield (a) and TGW (b) using the chromosome 1B high-resolution genetic map of Excalibur/Kukri DH population. P are the p-values for the test of QTL main effect (green line) and QTL by environment interactions (blue line) from the Wald test across 32 field trials.</a:t>
            </a:r>
            <a:r>
              <a:rPr lang="en-AU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96556D7-6096-694E-9BCA-20CEC03245F2}"/>
              </a:ext>
            </a:extLst>
          </p:cNvPr>
          <p:cNvSpPr txBox="1"/>
          <p:nvPr/>
        </p:nvSpPr>
        <p:spPr>
          <a:xfrm>
            <a:off x="247871" y="74588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B7A353B-735A-DD44-8056-455DBD8FD50F}"/>
              </a:ext>
            </a:extLst>
          </p:cNvPr>
          <p:cNvSpPr txBox="1"/>
          <p:nvPr/>
        </p:nvSpPr>
        <p:spPr>
          <a:xfrm>
            <a:off x="247871" y="387968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A425533-FC84-714A-8077-A6132A3CEA46}"/>
              </a:ext>
            </a:extLst>
          </p:cNvPr>
          <p:cNvSpPr/>
          <p:nvPr/>
        </p:nvSpPr>
        <p:spPr>
          <a:xfrm>
            <a:off x="369328" y="1496291"/>
            <a:ext cx="356681" cy="98829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CF157A67-F4BD-BF40-9D73-BDCCE1C27D1C}"/>
              </a:ext>
            </a:extLst>
          </p:cNvPr>
          <p:cNvSpPr/>
          <p:nvPr/>
        </p:nvSpPr>
        <p:spPr>
          <a:xfrm>
            <a:off x="399757" y="4563490"/>
            <a:ext cx="356681" cy="98829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B4EB9B5-C375-5244-880D-52F4B7026514}"/>
              </a:ext>
            </a:extLst>
          </p:cNvPr>
          <p:cNvSpPr txBox="1"/>
          <p:nvPr/>
        </p:nvSpPr>
        <p:spPr>
          <a:xfrm rot="16200000">
            <a:off x="182310" y="1777271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-log10(P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149D7EB-464E-904B-8256-296AECA2041A}"/>
              </a:ext>
            </a:extLst>
          </p:cNvPr>
          <p:cNvSpPr txBox="1"/>
          <p:nvPr/>
        </p:nvSpPr>
        <p:spPr>
          <a:xfrm rot="16200000">
            <a:off x="212727" y="4852330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-log10(P)</a:t>
            </a:r>
          </a:p>
        </p:txBody>
      </p:sp>
    </p:spTree>
    <p:extLst>
      <p:ext uri="{BB962C8B-B14F-4D97-AF65-F5344CB8AC3E}">
        <p14:creationId xmlns:p14="http://schemas.microsoft.com/office/powerpoint/2010/main" val="5724136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6</TotalTime>
  <Words>325</Words>
  <Application>Microsoft Office PowerPoint</Application>
  <PresentationFormat>On-screen Show (4:3)</PresentationFormat>
  <Paragraphs>2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phine Fleury</dc:creator>
  <cp:lastModifiedBy>Melissa Garcia</cp:lastModifiedBy>
  <cp:revision>31</cp:revision>
  <cp:lastPrinted>2019-04-01T03:24:04Z</cp:lastPrinted>
  <dcterms:created xsi:type="dcterms:W3CDTF">2018-09-26T05:40:27Z</dcterms:created>
  <dcterms:modified xsi:type="dcterms:W3CDTF">2019-07-04T07:00:43Z</dcterms:modified>
</cp:coreProperties>
</file>